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286" r:id="rId2"/>
  </p:sldIdLst>
  <p:sldSz cx="6858000" cy="9144000" type="letter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3" pos="3672" userDrawn="1">
          <p15:clr>
            <a:srgbClr val="A4A3A4"/>
          </p15:clr>
        </p15:guide>
        <p15:guide id="4" pos="648" userDrawn="1">
          <p15:clr>
            <a:srgbClr val="A4A3A4"/>
          </p15:clr>
        </p15:guide>
        <p15:guide id="5" orient="horz" pos="2496" userDrawn="1">
          <p15:clr>
            <a:srgbClr val="A4A3A4"/>
          </p15:clr>
        </p15:guide>
        <p15:guide id="6" orient="horz" pos="55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9F9F9F"/>
    <a:srgbClr val="C6C5C4"/>
    <a:srgbClr val="8D8C8A"/>
    <a:srgbClr val="525252"/>
    <a:srgbClr val="33CCCC"/>
    <a:srgbClr val="FF0000"/>
    <a:srgbClr val="C00000"/>
    <a:srgbClr val="408697"/>
    <a:srgbClr val="68000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DB3237A3-C8ED-4FDD-9653-DFB1A4E1C85B}" v="2" dt="2025-06-23T21:29:12.30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51" autoAdjust="0"/>
    <p:restoredTop sz="93447" autoAdjust="0"/>
  </p:normalViewPr>
  <p:slideViewPr>
    <p:cSldViewPr snapToGrid="0">
      <p:cViewPr varScale="1">
        <p:scale>
          <a:sx n="81" d="100"/>
          <a:sy n="81" d="100"/>
        </p:scale>
        <p:origin x="3048" y="90"/>
      </p:cViewPr>
      <p:guideLst>
        <p:guide pos="3672"/>
        <p:guide pos="648"/>
        <p:guide orient="horz" pos="2496"/>
        <p:guide orient="horz" pos="5520"/>
      </p:guideLst>
    </p:cSldViewPr>
  </p:slideViewPr>
  <p:outlineViewPr>
    <p:cViewPr>
      <p:scale>
        <a:sx n="33" d="100"/>
        <a:sy n="33" d="100"/>
      </p:scale>
      <p:origin x="0" y="-7419"/>
    </p:cViewPr>
  </p:outlineViewPr>
  <p:notesTextViewPr>
    <p:cViewPr>
      <p:scale>
        <a:sx n="400" d="100"/>
        <a:sy n="400" d="100"/>
      </p:scale>
      <p:origin x="0" y="0"/>
    </p:cViewPr>
  </p:notesTextViewPr>
  <p:sorterViewPr>
    <p:cViewPr>
      <p:scale>
        <a:sx n="74" d="100"/>
        <a:sy n="74" d="100"/>
      </p:scale>
      <p:origin x="0" y="0"/>
    </p:cViewPr>
  </p:sorterViewPr>
  <p:gridSpacing cx="182880" cy="18288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eike Schell" userId="+hwTHCJ9DPY+RcXtlOoxeiHCh/r8M9NERwcOBswqpyo=" providerId="None" clId="Web-{D0E174A4-FF77-410E-A064-A65E48C01CE0}"/>
    <pc:docChg chg="addSld modSld">
      <pc:chgData name="Mareike Schell" userId="+hwTHCJ9DPY+RcXtlOoxeiHCh/r8M9NERwcOBswqpyo=" providerId="None" clId="Web-{D0E174A4-FF77-410E-A064-A65E48C01CE0}" dt="2025-06-18T20:38:09.875" v="6"/>
      <pc:docMkLst>
        <pc:docMk/>
      </pc:docMkLst>
      <pc:sldChg chg="delSp">
        <pc:chgData name="Mareike Schell" userId="+hwTHCJ9DPY+RcXtlOoxeiHCh/r8M9NERwcOBswqpyo=" providerId="None" clId="Web-{D0E174A4-FF77-410E-A064-A65E48C01CE0}" dt="2025-06-18T20:38:07.875" v="5"/>
        <pc:sldMkLst>
          <pc:docMk/>
          <pc:sldMk cId="1691594351" sldId="2270"/>
        </pc:sldMkLst>
        <pc:spChg chg="del">
          <ac:chgData name="Mareike Schell" userId="+hwTHCJ9DPY+RcXtlOoxeiHCh/r8M9NERwcOBswqpyo=" providerId="None" clId="Web-{D0E174A4-FF77-410E-A064-A65E48C01CE0}" dt="2025-06-18T20:38:07.875" v="5"/>
          <ac:spMkLst>
            <pc:docMk/>
            <pc:sldMk cId="1691594351" sldId="2270"/>
            <ac:spMk id="4" creationId="{1EB32637-4065-5203-92A6-816C76BE9F93}"/>
          </ac:spMkLst>
        </pc:spChg>
        <pc:spChg chg="del">
          <ac:chgData name="Mareike Schell" userId="+hwTHCJ9DPY+RcXtlOoxeiHCh/r8M9NERwcOBswqpyo=" providerId="None" clId="Web-{D0E174A4-FF77-410E-A064-A65E48C01CE0}" dt="2025-06-18T20:38:07.875" v="4"/>
          <ac:spMkLst>
            <pc:docMk/>
            <pc:sldMk cId="1691594351" sldId="2270"/>
            <ac:spMk id="6" creationId="{2F9575D5-9BCF-EE54-D239-C7BA39B5210C}"/>
          </ac:spMkLst>
        </pc:spChg>
        <pc:spChg chg="del">
          <ac:chgData name="Mareike Schell" userId="+hwTHCJ9DPY+RcXtlOoxeiHCh/r8M9NERwcOBswqpyo=" providerId="None" clId="Web-{D0E174A4-FF77-410E-A064-A65E48C01CE0}" dt="2025-06-18T20:38:07.875" v="3"/>
          <ac:spMkLst>
            <pc:docMk/>
            <pc:sldMk cId="1691594351" sldId="2270"/>
            <ac:spMk id="7" creationId="{7713419C-40F1-166F-7685-12DD873E3889}"/>
          </ac:spMkLst>
        </pc:spChg>
        <pc:spChg chg="del">
          <ac:chgData name="Mareike Schell" userId="+hwTHCJ9DPY+RcXtlOoxeiHCh/r8M9NERwcOBswqpyo=" providerId="None" clId="Web-{D0E174A4-FF77-410E-A064-A65E48C01CE0}" dt="2025-06-18T20:38:07.875" v="2"/>
          <ac:spMkLst>
            <pc:docMk/>
            <pc:sldMk cId="1691594351" sldId="2270"/>
            <ac:spMk id="8" creationId="{5D6FC1C1-F155-861D-A7A1-E2651E6E9C66}"/>
          </ac:spMkLst>
        </pc:spChg>
        <pc:grpChg chg="del">
          <ac:chgData name="Mareike Schell" userId="+hwTHCJ9DPY+RcXtlOoxeiHCh/r8M9NERwcOBswqpyo=" providerId="None" clId="Web-{D0E174A4-FF77-410E-A064-A65E48C01CE0}" dt="2025-06-18T20:38:07.859" v="1"/>
          <ac:grpSpMkLst>
            <pc:docMk/>
            <pc:sldMk cId="1691594351" sldId="2270"/>
            <ac:grpSpMk id="9" creationId="{CC359C9F-7BC9-47CF-BEFC-0DA61A45203F}"/>
          </ac:grpSpMkLst>
        </pc:grpChg>
      </pc:sldChg>
      <pc:sldChg chg="addSp new">
        <pc:chgData name="Mareike Schell" userId="+hwTHCJ9DPY+RcXtlOoxeiHCh/r8M9NERwcOBswqpyo=" providerId="None" clId="Web-{D0E174A4-FF77-410E-A064-A65E48C01CE0}" dt="2025-06-18T20:38:09.875" v="6"/>
        <pc:sldMkLst>
          <pc:docMk/>
          <pc:sldMk cId="2105458467" sldId="2283"/>
        </pc:sldMkLst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4" creationId="{7713419C-40F1-166F-7685-12DD873E3889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9" creationId="{E33C9E2D-3BA5-16D6-C965-E9A2AD306141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10" creationId="{9BC17AB2-4076-8BD3-A3E3-58C3B64B6488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11" creationId="{8C21F97A-DCFA-6FE3-FC8F-60F295899015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14" creationId="{B7B2A7CA-C92B-A038-8147-A0958F7DCF6B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0" creationId="{618AA4CC-3E26-D8A3-AC7A-15E7738EF09B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1" creationId="{78CEB8C7-CC3D-BB06-5B57-E3A826AC8C92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3" creationId="{A42A442F-B98B-706D-6B50-F9D813670D0B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4" creationId="{E16C5DE1-F2ED-1EB1-FF6C-08C5706DA404}"/>
          </ac:spMkLst>
        </pc:spChg>
        <pc:spChg chg="add">
          <ac:chgData name="Mareike Schell" userId="+hwTHCJ9DPY+RcXtlOoxeiHCh/r8M9NERwcOBswqpyo=" providerId="None" clId="Web-{D0E174A4-FF77-410E-A064-A65E48C01CE0}" dt="2025-06-18T20:38:09.875" v="6"/>
          <ac:spMkLst>
            <pc:docMk/>
            <pc:sldMk cId="2105458467" sldId="2283"/>
            <ac:spMk id="28" creationId="{EE79737A-C9DC-B00F-B02E-DD9960F96B8E}"/>
          </ac:spMkLst>
        </pc:spChg>
      </pc:sldChg>
    </pc:docChg>
  </pc:docChgLst>
  <pc:docChgLst>
    <pc:chgData name="Mareike Schell" userId="+hwTHCJ9DPY+RcXtlOoxeiHCh/r8M9NERwcOBswqpyo=" providerId="None" clId="Web-{DB3237A3-C8ED-4FDD-9653-DFB1A4E1C85B}"/>
    <pc:docChg chg="modSld">
      <pc:chgData name="Mareike Schell" userId="+hwTHCJ9DPY+RcXtlOoxeiHCh/r8M9NERwcOBswqpyo=" providerId="None" clId="Web-{DB3237A3-C8ED-4FDD-9653-DFB1A4E1C85B}" dt="2025-06-23T21:29:12.304" v="1" actId="1076"/>
      <pc:docMkLst>
        <pc:docMk/>
      </pc:docMkLst>
      <pc:sldChg chg="modSp">
        <pc:chgData name="Mareike Schell" userId="+hwTHCJ9DPY+RcXtlOoxeiHCh/r8M9NERwcOBswqpyo=" providerId="None" clId="Web-{DB3237A3-C8ED-4FDD-9653-DFB1A4E1C85B}" dt="2025-06-23T21:29:12.304" v="1" actId="1076"/>
        <pc:sldMkLst>
          <pc:docMk/>
          <pc:sldMk cId="957714345" sldId="2282"/>
        </pc:sldMkLst>
        <pc:spChg chg="mod">
          <ac:chgData name="Mareike Schell" userId="+hwTHCJ9DPY+RcXtlOoxeiHCh/r8M9NERwcOBswqpyo=" providerId="None" clId="Web-{DB3237A3-C8ED-4FDD-9653-DFB1A4E1C85B}" dt="2025-06-23T21:29:12.304" v="1" actId="1076"/>
          <ac:spMkLst>
            <pc:docMk/>
            <pc:sldMk cId="957714345" sldId="2282"/>
            <ac:spMk id="406" creationId="{944DE7CF-CC9C-B0F5-5AB0-2468A2E26644}"/>
          </ac:spMkLst>
        </pc:spChg>
      </pc:sldChg>
    </pc:docChg>
  </pc:docChgLst>
  <pc:docChgLst>
    <pc:chgData name="Mareike Schell" userId="+hwTHCJ9DPY+RcXtlOoxeiHCh/r8M9NERwcOBswqpyo=" providerId="None" clId="Web-{92842568-ACA6-4FF0-B290-0595DDCEF770}"/>
    <pc:docChg chg="modSld">
      <pc:chgData name="Mareike Schell" userId="+hwTHCJ9DPY+RcXtlOoxeiHCh/r8M9NERwcOBswqpyo=" providerId="None" clId="Web-{92842568-ACA6-4FF0-B290-0595DDCEF770}" dt="2025-05-02T22:19:57.215" v="187"/>
      <pc:docMkLst>
        <pc:docMk/>
      </pc:docMkLst>
      <pc:sldChg chg="addSp delSp modSp">
        <pc:chgData name="Mareike Schell" userId="+hwTHCJ9DPY+RcXtlOoxeiHCh/r8M9NERwcOBswqpyo=" providerId="None" clId="Web-{92842568-ACA6-4FF0-B290-0595DDCEF770}" dt="2025-05-02T22:17:23.756" v="140"/>
        <pc:sldMkLst>
          <pc:docMk/>
          <pc:sldMk cId="4273005573" sldId="2276"/>
        </pc:sldMkLst>
        <pc:spChg chg="del mod">
          <ac:chgData name="Mareike Schell" userId="+hwTHCJ9DPY+RcXtlOoxeiHCh/r8M9NERwcOBswqpyo=" providerId="None" clId="Web-{92842568-ACA6-4FF0-B290-0595DDCEF770}" dt="2025-05-02T22:17:23.756" v="138"/>
          <ac:spMkLst>
            <pc:docMk/>
            <pc:sldMk cId="4273005573" sldId="2276"/>
            <ac:spMk id="4" creationId="{7476FED3-6C14-9CA0-7EF0-ADF11E285B26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7"/>
          <ac:spMkLst>
            <pc:docMk/>
            <pc:sldMk cId="4273005573" sldId="2276"/>
            <ac:spMk id="5" creationId="{E3C59D4F-2741-7324-DA74-C21FD86C6C13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6"/>
          <ac:spMkLst>
            <pc:docMk/>
            <pc:sldMk cId="4273005573" sldId="2276"/>
            <ac:spMk id="6" creationId="{CACE87EA-B2AA-CAF5-88EA-9769811A81B9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5"/>
          <ac:spMkLst>
            <pc:docMk/>
            <pc:sldMk cId="4273005573" sldId="2276"/>
            <ac:spMk id="8" creationId="{2D886CBF-BFAA-2E47-805D-35FCA336A757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40"/>
          <ac:spMkLst>
            <pc:docMk/>
            <pc:sldMk cId="4273005573" sldId="2276"/>
            <ac:spMk id="123" creationId="{1C139171-2D45-B7BD-65B7-87213805B36A}"/>
          </ac:spMkLst>
        </pc:spChg>
        <pc:spChg chg="del mod">
          <ac:chgData name="Mareike Schell" userId="+hwTHCJ9DPY+RcXtlOoxeiHCh/r8M9NERwcOBswqpyo=" providerId="None" clId="Web-{92842568-ACA6-4FF0-B290-0595DDCEF770}" dt="2025-05-02T22:17:23.756" v="139"/>
          <ac:spMkLst>
            <pc:docMk/>
            <pc:sldMk cId="4273005573" sldId="2276"/>
            <ac:spMk id="124" creationId="{74010334-5A8C-8AB3-3B8C-71654DF3E834}"/>
          </ac:spMkLst>
        </pc:spChg>
        <pc:cxnChg chg="add del mod">
          <ac:chgData name="Mareike Schell" userId="+hwTHCJ9DPY+RcXtlOoxeiHCh/r8M9NERwcOBswqpyo=" providerId="None" clId="Web-{92842568-ACA6-4FF0-B290-0595DDCEF770}" dt="2025-05-02T22:14:24.031" v="100"/>
          <ac:cxnSpMkLst>
            <pc:docMk/>
            <pc:sldMk cId="4273005573" sldId="2276"/>
            <ac:cxnSpMk id="2" creationId="{CECF07A4-3230-F0C6-0DE9-4B570FC92AA6}"/>
          </ac:cxnSpMkLst>
        </pc:cxnChg>
      </pc:sldChg>
      <pc:sldChg chg="addSp delSp modSp">
        <pc:chgData name="Mareike Schell" userId="+hwTHCJ9DPY+RcXtlOoxeiHCh/r8M9NERwcOBswqpyo=" providerId="None" clId="Web-{92842568-ACA6-4FF0-B290-0595DDCEF770}" dt="2025-05-02T22:19:57.215" v="187"/>
        <pc:sldMkLst>
          <pc:docMk/>
          <pc:sldMk cId="459051783" sldId="2280"/>
        </pc:sldMkLst>
        <pc:spChg chg="del">
          <ac:chgData name="Mareike Schell" userId="+hwTHCJ9DPY+RcXtlOoxeiHCh/r8M9NERwcOBswqpyo=" providerId="None" clId="Web-{92842568-ACA6-4FF0-B290-0595DDCEF770}" dt="2025-05-02T22:16:59.786" v="132"/>
          <ac:spMkLst>
            <pc:docMk/>
            <pc:sldMk cId="459051783" sldId="2280"/>
            <ac:spMk id="11" creationId="{A8EB7B5A-443C-867C-CA7A-A53CC47CDCB1}"/>
          </ac:spMkLst>
        </pc:spChg>
        <pc:spChg chg="add mod">
          <ac:chgData name="Mareike Schell" userId="+hwTHCJ9DPY+RcXtlOoxeiHCh/r8M9NERwcOBswqpyo=" providerId="None" clId="Web-{92842568-ACA6-4FF0-B290-0595DDCEF770}" dt="2025-05-02T22:18:03.132" v="158" actId="1076"/>
          <ac:spMkLst>
            <pc:docMk/>
            <pc:sldMk cId="459051783" sldId="2280"/>
            <ac:spMk id="12" creationId="{1C139171-2D45-B7BD-65B7-87213805B36A}"/>
          </ac:spMkLst>
        </pc:spChg>
        <pc:spChg chg="add mod">
          <ac:chgData name="Mareike Schell" userId="+hwTHCJ9DPY+RcXtlOoxeiHCh/r8M9NERwcOBswqpyo=" providerId="None" clId="Web-{92842568-ACA6-4FF0-B290-0595DDCEF770}" dt="2025-05-02T22:18:03.164" v="159" actId="1076"/>
          <ac:spMkLst>
            <pc:docMk/>
            <pc:sldMk cId="459051783" sldId="2280"/>
            <ac:spMk id="13" creationId="{74010334-5A8C-8AB3-3B8C-71654DF3E834}"/>
          </ac:spMkLst>
        </pc:spChg>
        <pc:spChg chg="add mod">
          <ac:chgData name="Mareike Schell" userId="+hwTHCJ9DPY+RcXtlOoxeiHCh/r8M9NERwcOBswqpyo=" providerId="None" clId="Web-{92842568-ACA6-4FF0-B290-0595DDCEF770}" dt="2025-05-02T22:19:29.245" v="179" actId="1076"/>
          <ac:spMkLst>
            <pc:docMk/>
            <pc:sldMk cId="459051783" sldId="2280"/>
            <ac:spMk id="14" creationId="{7476FED3-6C14-9CA0-7EF0-ADF11E285B26}"/>
          </ac:spMkLst>
        </pc:spChg>
        <pc:spChg chg="add mod">
          <ac:chgData name="Mareike Schell" userId="+hwTHCJ9DPY+RcXtlOoxeiHCh/r8M9NERwcOBswqpyo=" providerId="None" clId="Web-{92842568-ACA6-4FF0-B290-0595DDCEF770}" dt="2025-05-02T22:18:03.257" v="161" actId="1076"/>
          <ac:spMkLst>
            <pc:docMk/>
            <pc:sldMk cId="459051783" sldId="2280"/>
            <ac:spMk id="23" creationId="{E3C59D4F-2741-7324-DA74-C21FD86C6C13}"/>
          </ac:spMkLst>
        </pc:spChg>
        <pc:spChg chg="add mod">
          <ac:chgData name="Mareike Schell" userId="+hwTHCJ9DPY+RcXtlOoxeiHCh/r8M9NERwcOBswqpyo=" providerId="None" clId="Web-{92842568-ACA6-4FF0-B290-0595DDCEF770}" dt="2025-05-02T22:18:03.289" v="162" actId="1076"/>
          <ac:spMkLst>
            <pc:docMk/>
            <pc:sldMk cId="459051783" sldId="2280"/>
            <ac:spMk id="24" creationId="{CACE87EA-B2AA-CAF5-88EA-9769811A81B9}"/>
          </ac:spMkLst>
        </pc:spChg>
        <pc:spChg chg="add mod">
          <ac:chgData name="Mareike Schell" userId="+hwTHCJ9DPY+RcXtlOoxeiHCh/r8M9NERwcOBswqpyo=" providerId="None" clId="Web-{92842568-ACA6-4FF0-B290-0595DDCEF770}" dt="2025-05-02T22:18:03.320" v="163" actId="1076"/>
          <ac:spMkLst>
            <pc:docMk/>
            <pc:sldMk cId="459051783" sldId="2280"/>
            <ac:spMk id="25" creationId="{2D886CBF-BFAA-2E47-805D-35FCA336A757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28" creationId="{DD7E0284-6262-AE94-F830-FBF0417BEC52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30" creationId="{209BF54C-DFEA-0F7F-5D44-9D598493C30D}"/>
          </ac:spMkLst>
        </pc:spChg>
        <pc:spChg chg="mod">
          <ac:chgData name="Mareike Schell" userId="+hwTHCJ9DPY+RcXtlOoxeiHCh/r8M9NERwcOBswqpyo=" providerId="None" clId="Web-{92842568-ACA6-4FF0-B290-0595DDCEF770}" dt="2025-05-02T22:19:44.136" v="185" actId="1076"/>
          <ac:spMkLst>
            <pc:docMk/>
            <pc:sldMk cId="459051783" sldId="2280"/>
            <ac:spMk id="34" creationId="{27DEC4EB-8210-F330-8699-9B4A582A7DA1}"/>
          </ac:spMkLst>
        </pc:spChg>
        <pc:spChg chg="mod">
          <ac:chgData name="Mareike Schell" userId="+hwTHCJ9DPY+RcXtlOoxeiHCh/r8M9NERwcOBswqpyo=" providerId="None" clId="Web-{92842568-ACA6-4FF0-B290-0595DDCEF770}" dt="2025-05-02T22:19:29.182" v="177" actId="1076"/>
          <ac:spMkLst>
            <pc:docMk/>
            <pc:sldMk cId="459051783" sldId="2280"/>
            <ac:spMk id="65" creationId="{3353F172-8E2D-D17D-3089-70122D299134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66" creationId="{4692D747-95A7-FDA9-F3FB-00E230374148}"/>
          </ac:spMkLst>
        </pc:spChg>
        <pc:spChg chg="mod">
          <ac:chgData name="Mareike Schell" userId="+hwTHCJ9DPY+RcXtlOoxeiHCh/r8M9NERwcOBswqpyo=" providerId="None" clId="Web-{92842568-ACA6-4FF0-B290-0595DDCEF770}" dt="2025-05-02T22:19:34.057" v="181" actId="1076"/>
          <ac:spMkLst>
            <pc:docMk/>
            <pc:sldMk cId="459051783" sldId="2280"/>
            <ac:spMk id="69" creationId="{B6CC28BD-61EC-758A-CEE0-4810A441FA91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84" creationId="{0306307D-B979-D43B-CD11-5AE5124C31E6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88" creationId="{1E9BE69A-D0CF-B0AC-A1AC-375B5A6B1F22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00" creationId="{2A182F72-85E1-A235-B8EA-C99C7A24AFA4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07" creationId="{B2F1C922-B519-0F24-A40B-A78B65B80F09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12" creationId="{B422BFCF-499A-1EA2-D6B4-9409148052D0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16" creationId="{E208B5B3-F7AB-8B7C-948B-C25340F795D0}"/>
          </ac:spMkLst>
        </pc:spChg>
        <pc:spChg chg="mod">
          <ac:chgData name="Mareike Schell" userId="+hwTHCJ9DPY+RcXtlOoxeiHCh/r8M9NERwcOBswqpyo=" providerId="None" clId="Web-{92842568-ACA6-4FF0-B290-0595DDCEF770}" dt="2025-05-02T22:19:29.214" v="178" actId="1076"/>
          <ac:spMkLst>
            <pc:docMk/>
            <pc:sldMk cId="459051783" sldId="2280"/>
            <ac:spMk id="119" creationId="{4ED3FE10-5FD8-8676-BA03-9EBEF5283149}"/>
          </ac:spMkLst>
        </pc:spChg>
        <pc:spChg chg="topLvl">
          <ac:chgData name="Mareike Schell" userId="+hwTHCJ9DPY+RcXtlOoxeiHCh/r8M9NERwcOBswqpyo=" providerId="None" clId="Web-{92842568-ACA6-4FF0-B290-0595DDCEF770}" dt="2025-05-02T22:19:17.760" v="175"/>
          <ac:spMkLst>
            <pc:docMk/>
            <pc:sldMk cId="459051783" sldId="2280"/>
            <ac:spMk id="120" creationId="{8922343C-9A58-2616-5BF6-687FBC2BF168}"/>
          </ac:spMkLst>
        </pc:spChg>
        <pc:grpChg chg="add del">
          <ac:chgData name="Mareike Schell" userId="+hwTHCJ9DPY+RcXtlOoxeiHCh/r8M9NERwcOBswqpyo=" providerId="None" clId="Web-{92842568-ACA6-4FF0-B290-0595DDCEF770}" dt="2025-05-02T22:17:28.194" v="141"/>
          <ac:grpSpMkLst>
            <pc:docMk/>
            <pc:sldMk cId="459051783" sldId="2280"/>
            <ac:grpSpMk id="2" creationId="{908CE240-C904-3ADB-540F-6998173295B9}"/>
          </ac:grpSpMkLst>
        </pc:grpChg>
        <pc:graphicFrameChg chg="mod">
          <ac:chgData name="Mareike Schell" userId="+hwTHCJ9DPY+RcXtlOoxeiHCh/r8M9NERwcOBswqpyo=" providerId="None" clId="Web-{92842568-ACA6-4FF0-B290-0595DDCEF770}" dt="2025-05-02T22:19:44.105" v="184" actId="1076"/>
          <ac:graphicFrameMkLst>
            <pc:docMk/>
            <pc:sldMk cId="459051783" sldId="2280"/>
            <ac:graphicFrameMk id="32" creationId="{8323550C-CAA8-CD19-AAB1-16F8DE4BA7D2}"/>
          </ac:graphicFrameMkLst>
        </pc:graphicFrameChg>
        <pc:graphicFrameChg chg="mod">
          <ac:chgData name="Mareike Schell" userId="+hwTHCJ9DPY+RcXtlOoxeiHCh/r8M9NERwcOBswqpyo=" providerId="None" clId="Web-{92842568-ACA6-4FF0-B290-0595DDCEF770}" dt="2025-05-02T22:19:29.151" v="176" actId="1076"/>
          <ac:graphicFrameMkLst>
            <pc:docMk/>
            <pc:sldMk cId="459051783" sldId="2280"/>
            <ac:graphicFrameMk id="63" creationId="{64D06C85-6552-E708-267A-5E8DC415877E}"/>
          </ac:graphicFrameMkLst>
        </pc:graphicFrameChg>
        <pc:graphicFrameChg chg="mod">
          <ac:chgData name="Mareike Schell" userId="+hwTHCJ9DPY+RcXtlOoxeiHCh/r8M9NERwcOBswqpyo=" providerId="None" clId="Web-{92842568-ACA6-4FF0-B290-0595DDCEF770}" dt="2025-05-02T22:19:34.011" v="180" actId="1076"/>
          <ac:graphicFrameMkLst>
            <pc:docMk/>
            <pc:sldMk cId="459051783" sldId="2280"/>
            <ac:graphicFrameMk id="68" creationId="{9868219A-2DDE-D7AE-E945-D36EAEFADBB6}"/>
          </ac:graphicFrameMkLst>
        </pc:graphicFrameChg>
        <pc:cxnChg chg="add del mod">
          <ac:chgData name="Mareike Schell" userId="+hwTHCJ9DPY+RcXtlOoxeiHCh/r8M9NERwcOBswqpyo=" providerId="None" clId="Web-{92842568-ACA6-4FF0-B290-0595DDCEF770}" dt="2025-05-02T22:19:57.215" v="187"/>
          <ac:cxnSpMkLst>
            <pc:docMk/>
            <pc:sldMk cId="459051783" sldId="2280"/>
            <ac:cxnSpMk id="26" creationId="{F1B4FF4F-98B5-EA33-1243-2009F14444E9}"/>
          </ac:cxnSpMkLst>
        </pc:cxnChg>
      </pc:sldChg>
    </pc:docChg>
  </pc:docChgLst>
  <pc:docChgLst>
    <pc:chgData name="Mareike Schell" userId="+hwTHCJ9DPY+RcXtlOoxeiHCh/r8M9NERwcOBswqpyo=" providerId="None" clId="Web-{105243D0-230D-4A85-9D06-0BF99DA71ECB}"/>
    <pc:docChg chg="modSld sldOrd">
      <pc:chgData name="Mareike Schell" userId="+hwTHCJ9DPY+RcXtlOoxeiHCh/r8M9NERwcOBswqpyo=" providerId="None" clId="Web-{105243D0-230D-4A85-9D06-0BF99DA71ECB}" dt="2025-06-20T20:45:51.369" v="3" actId="20577"/>
      <pc:docMkLst>
        <pc:docMk/>
      </pc:docMkLst>
      <pc:sldChg chg="modSp">
        <pc:chgData name="Mareike Schell" userId="+hwTHCJ9DPY+RcXtlOoxeiHCh/r8M9NERwcOBswqpyo=" providerId="None" clId="Web-{105243D0-230D-4A85-9D06-0BF99DA71ECB}" dt="2025-06-20T20:45:51.369" v="3" actId="20577"/>
        <pc:sldMkLst>
          <pc:docMk/>
          <pc:sldMk cId="604687140" sldId="2262"/>
        </pc:sldMkLst>
        <pc:spChg chg="mod">
          <ac:chgData name="Mareike Schell" userId="+hwTHCJ9DPY+RcXtlOoxeiHCh/r8M9NERwcOBswqpyo=" providerId="None" clId="Web-{105243D0-230D-4A85-9D06-0BF99DA71ECB}" dt="2025-06-20T20:45:51.369" v="3" actId="20577"/>
          <ac:spMkLst>
            <pc:docMk/>
            <pc:sldMk cId="604687140" sldId="2262"/>
            <ac:spMk id="211" creationId="{174E3E88-3800-7243-D6A2-12C1978CFDD7}"/>
          </ac:spMkLst>
        </pc:spChg>
      </pc:sldChg>
      <pc:sldChg chg="modSp ord">
        <pc:chgData name="Mareike Schell" userId="+hwTHCJ9DPY+RcXtlOoxeiHCh/r8M9NERwcOBswqpyo=" providerId="None" clId="Web-{105243D0-230D-4A85-9D06-0BF99DA71ECB}" dt="2025-06-20T20:45:47.165" v="2" actId="20577"/>
        <pc:sldMkLst>
          <pc:docMk/>
          <pc:sldMk cId="2105458467" sldId="2283"/>
        </pc:sldMkLst>
        <pc:spChg chg="mod">
          <ac:chgData name="Mareike Schell" userId="+hwTHCJ9DPY+RcXtlOoxeiHCh/r8M9NERwcOBswqpyo=" providerId="None" clId="Web-{105243D0-230D-4A85-9D06-0BF99DA71ECB}" dt="2025-06-20T20:45:47.165" v="2" actId="20577"/>
          <ac:spMkLst>
            <pc:docMk/>
            <pc:sldMk cId="2105458467" sldId="2283"/>
            <ac:spMk id="7" creationId="{7730057E-B75C-B8F1-09E6-EF14151BAC4A}"/>
          </ac:spMkLst>
        </pc:spChg>
      </pc:sldChg>
    </pc:docChg>
  </pc:docChgLst>
  <pc:docChgLst>
    <pc:chgData name="Mareike Schell" userId="+hwTHCJ9DPY+RcXtlOoxeiHCh/r8M9NERwcOBswqpyo=" providerId="None" clId="Web-{9ADCC2D3-70B3-4043-AB62-6F6C91297EF6}"/>
    <pc:docChg chg="modSld">
      <pc:chgData name="Mareike Schell" userId="+hwTHCJ9DPY+RcXtlOoxeiHCh/r8M9NERwcOBswqpyo=" providerId="None" clId="Web-{9ADCC2D3-70B3-4043-AB62-6F6C91297EF6}" dt="2025-05-02T23:23:05.316" v="6" actId="20577"/>
      <pc:docMkLst>
        <pc:docMk/>
      </pc:docMkLst>
      <pc:sldChg chg="modSp">
        <pc:chgData name="Mareike Schell" userId="+hwTHCJ9DPY+RcXtlOoxeiHCh/r8M9NERwcOBswqpyo=" providerId="None" clId="Web-{9ADCC2D3-70B3-4043-AB62-6F6C91297EF6}" dt="2025-05-02T23:22:52.659" v="4" actId="20577"/>
        <pc:sldMkLst>
          <pc:docMk/>
          <pc:sldMk cId="3419203025" sldId="2260"/>
        </pc:sldMkLst>
        <pc:spChg chg="mod">
          <ac:chgData name="Mareike Schell" userId="+hwTHCJ9DPY+RcXtlOoxeiHCh/r8M9NERwcOBswqpyo=" providerId="None" clId="Web-{9ADCC2D3-70B3-4043-AB62-6F6C91297EF6}" dt="2025-05-02T23:22:52.659" v="4" actId="20577"/>
          <ac:spMkLst>
            <pc:docMk/>
            <pc:sldMk cId="3419203025" sldId="2260"/>
            <ac:spMk id="252" creationId="{1BF8FC5C-5A86-EF66-E60A-C0E4B0A1E09E}"/>
          </ac:spMkLst>
        </pc:spChg>
      </pc:sldChg>
      <pc:sldChg chg="modSp">
        <pc:chgData name="Mareike Schell" userId="+hwTHCJ9DPY+RcXtlOoxeiHCh/r8M9NERwcOBswqpyo=" providerId="None" clId="Web-{9ADCC2D3-70B3-4043-AB62-6F6C91297EF6}" dt="2025-05-02T23:23:05.316" v="6" actId="20577"/>
        <pc:sldMkLst>
          <pc:docMk/>
          <pc:sldMk cId="604687140" sldId="2262"/>
        </pc:sldMkLst>
        <pc:spChg chg="mod">
          <ac:chgData name="Mareike Schell" userId="+hwTHCJ9DPY+RcXtlOoxeiHCh/r8M9NERwcOBswqpyo=" providerId="None" clId="Web-{9ADCC2D3-70B3-4043-AB62-6F6C91297EF6}" dt="2025-05-02T23:23:05.316" v="6" actId="20577"/>
          <ac:spMkLst>
            <pc:docMk/>
            <pc:sldMk cId="604687140" sldId="2262"/>
            <ac:spMk id="271" creationId="{39C151FB-3E65-7BA5-BD19-E8588ED1F7B0}"/>
          </ac:spMkLst>
        </pc:spChg>
      </pc:sldChg>
    </pc:docChg>
  </pc:docChgLst>
  <pc:docChgLst>
    <pc:chgData name="Mareike Schell" userId="+hwTHCJ9DPY+RcXtlOoxeiHCh/r8M9NERwcOBswqpyo=" providerId="None" clId="Web-{6C2CC828-A83C-4AAC-92D0-9AF3D4BC5B7A}"/>
    <pc:docChg chg="delSld">
      <pc:chgData name="Mareike Schell" userId="+hwTHCJ9DPY+RcXtlOoxeiHCh/r8M9NERwcOBswqpyo=" providerId="None" clId="Web-{6C2CC828-A83C-4AAC-92D0-9AF3D4BC5B7A}" dt="2025-05-03T23:31:10.031" v="4"/>
      <pc:docMkLst>
        <pc:docMk/>
      </pc:docMkLst>
      <pc:sldChg chg="del">
        <pc:chgData name="Mareike Schell" userId="+hwTHCJ9DPY+RcXtlOoxeiHCh/r8M9NERwcOBswqpyo=" providerId="None" clId="Web-{6C2CC828-A83C-4AAC-92D0-9AF3D4BC5B7A}" dt="2025-05-03T23:31:10.031" v="4"/>
        <pc:sldMkLst>
          <pc:docMk/>
          <pc:sldMk cId="1311454994" sldId="2269"/>
        </pc:sldMkLst>
      </pc:sldChg>
      <pc:sldChg chg="del">
        <pc:chgData name="Mareike Schell" userId="+hwTHCJ9DPY+RcXtlOoxeiHCh/r8M9NERwcOBswqpyo=" providerId="None" clId="Web-{6C2CC828-A83C-4AAC-92D0-9AF3D4BC5B7A}" dt="2025-05-03T23:31:01.764" v="0"/>
        <pc:sldMkLst>
          <pc:docMk/>
          <pc:sldMk cId="2534225001" sldId="2276"/>
        </pc:sldMkLst>
      </pc:sldChg>
      <pc:sldChg chg="del">
        <pc:chgData name="Mareike Schell" userId="+hwTHCJ9DPY+RcXtlOoxeiHCh/r8M9NERwcOBswqpyo=" providerId="None" clId="Web-{6C2CC828-A83C-4AAC-92D0-9AF3D4BC5B7A}" dt="2025-05-03T23:31:06.343" v="2"/>
        <pc:sldMkLst>
          <pc:docMk/>
          <pc:sldMk cId="121866281" sldId="2278"/>
        </pc:sldMkLst>
      </pc:sldChg>
      <pc:sldChg chg="del">
        <pc:chgData name="Mareike Schell" userId="+hwTHCJ9DPY+RcXtlOoxeiHCh/r8M9NERwcOBswqpyo=" providerId="None" clId="Web-{6C2CC828-A83C-4AAC-92D0-9AF3D4BC5B7A}" dt="2025-05-03T23:31:04.296" v="1"/>
        <pc:sldMkLst>
          <pc:docMk/>
          <pc:sldMk cId="263700232" sldId="2279"/>
        </pc:sldMkLst>
      </pc:sldChg>
      <pc:sldChg chg="del">
        <pc:chgData name="Mareike Schell" userId="+hwTHCJ9DPY+RcXtlOoxeiHCh/r8M9NERwcOBswqpyo=" providerId="None" clId="Web-{6C2CC828-A83C-4AAC-92D0-9AF3D4BC5B7A}" dt="2025-05-03T23:31:08.421" v="3"/>
        <pc:sldMkLst>
          <pc:docMk/>
          <pc:sldMk cId="1470452761" sldId="2282"/>
        </pc:sldMkLst>
      </pc:sldChg>
    </pc:docChg>
  </pc:docChgLst>
  <pc:docChgLst>
    <pc:chgData name="Mareike Schell" userId="+hwTHCJ9DPY+RcXtlOoxeiHCh/r8M9NERwcOBswqpyo=" providerId="None" clId="Web-{6B771CB8-5B8A-46C4-BD43-ECA176944BA4}"/>
    <pc:docChg chg="modSld">
      <pc:chgData name="Mareike Schell" userId="+hwTHCJ9DPY+RcXtlOoxeiHCh/r8M9NERwcOBswqpyo=" providerId="None" clId="Web-{6B771CB8-5B8A-46C4-BD43-ECA176944BA4}" dt="2025-06-05T15:12:30.297" v="7" actId="1076"/>
      <pc:docMkLst>
        <pc:docMk/>
      </pc:docMkLst>
      <pc:sldChg chg="addSp modSp">
        <pc:chgData name="Mareike Schell" userId="+hwTHCJ9DPY+RcXtlOoxeiHCh/r8M9NERwcOBswqpyo=" providerId="None" clId="Web-{6B771CB8-5B8A-46C4-BD43-ECA176944BA4}" dt="2025-06-05T15:12:30.297" v="7" actId="1076"/>
        <pc:sldMkLst>
          <pc:docMk/>
          <pc:sldMk cId="1691594351" sldId="2270"/>
        </pc:sldMkLst>
        <pc:spChg chg="add mod">
          <ac:chgData name="Mareike Schell" userId="+hwTHCJ9DPY+RcXtlOoxeiHCh/r8M9NERwcOBswqpyo=" providerId="None" clId="Web-{6B771CB8-5B8A-46C4-BD43-ECA176944BA4}" dt="2025-06-05T15:12:30.297" v="7" actId="1076"/>
          <ac:spMkLst>
            <pc:docMk/>
            <pc:sldMk cId="1691594351" sldId="2270"/>
            <ac:spMk id="22" creationId="{42A24069-71DE-949D-E209-59B51AC2C383}"/>
          </ac:spMkLst>
        </pc:spChg>
        <pc:spChg chg="mod">
          <ac:chgData name="Mareike Schell" userId="+hwTHCJ9DPY+RcXtlOoxeiHCh/r8M9NERwcOBswqpyo=" providerId="None" clId="Web-{6B771CB8-5B8A-46C4-BD43-ECA176944BA4}" dt="2025-06-05T15:12:12.969" v="3" actId="20577"/>
          <ac:spMkLst>
            <pc:docMk/>
            <pc:sldMk cId="1691594351" sldId="2270"/>
            <ac:spMk id="34" creationId="{833BF64A-985B-6CFD-BA2F-30B59E3BBD1A}"/>
          </ac:spMkLst>
        </pc:spChg>
      </pc:sldChg>
    </pc:docChg>
  </pc:docChgLst>
  <pc:docChgLst>
    <pc:chgData name="Mareike Schell" userId="+hwTHCJ9DPY+RcXtlOoxeiHCh/r8M9NERwcOBswqpyo=" providerId="None" clId="Web-{2165B5CB-A405-40F9-9B6D-C976A6FD1273}"/>
    <pc:docChg chg="modSld">
      <pc:chgData name="Mareike Schell" userId="+hwTHCJ9DPY+RcXtlOoxeiHCh/r8M9NERwcOBswqpyo=" providerId="None" clId="Web-{2165B5CB-A405-40F9-9B6D-C976A6FD1273}" dt="2025-06-18T20:41:44.502" v="68"/>
      <pc:docMkLst>
        <pc:docMk/>
      </pc:docMkLst>
      <pc:sldChg chg="addSp delSp modSp">
        <pc:chgData name="Mareike Schell" userId="+hwTHCJ9DPY+RcXtlOoxeiHCh/r8M9NERwcOBswqpyo=" providerId="None" clId="Web-{2165B5CB-A405-40F9-9B6D-C976A6FD1273}" dt="2025-06-18T20:41:44.502" v="68"/>
        <pc:sldMkLst>
          <pc:docMk/>
          <pc:sldMk cId="2105458467" sldId="2283"/>
        </pc:sldMkLst>
        <pc:spChg chg="mod">
          <ac:chgData name="Mareike Schell" userId="+hwTHCJ9DPY+RcXtlOoxeiHCh/r8M9NERwcOBswqpyo=" providerId="None" clId="Web-{2165B5CB-A405-40F9-9B6D-C976A6FD1273}" dt="2025-06-18T20:41:29.095" v="59" actId="1076"/>
          <ac:spMkLst>
            <pc:docMk/>
            <pc:sldMk cId="2105458467" sldId="2283"/>
            <ac:spMk id="20" creationId="{618AA4CC-3E26-D8A3-AC7A-15E7738EF09B}"/>
          </ac:spMkLst>
        </pc:spChg>
        <pc:spChg chg="del mod">
          <ac:chgData name="Mareike Schell" userId="+hwTHCJ9DPY+RcXtlOoxeiHCh/r8M9NERwcOBswqpyo=" providerId="None" clId="Web-{2165B5CB-A405-40F9-9B6D-C976A6FD1273}" dt="2025-06-18T20:40:35.718" v="21"/>
          <ac:spMkLst>
            <pc:docMk/>
            <pc:sldMk cId="2105458467" sldId="2283"/>
            <ac:spMk id="21" creationId="{78CEB8C7-CC3D-BB06-5B57-E3A826AC8C92}"/>
          </ac:spMkLst>
        </pc:spChg>
        <pc:spChg chg="mod">
          <ac:chgData name="Mareike Schell" userId="+hwTHCJ9DPY+RcXtlOoxeiHCh/r8M9NERwcOBswqpyo=" providerId="None" clId="Web-{2165B5CB-A405-40F9-9B6D-C976A6FD1273}" dt="2025-06-18T20:41:29.173" v="60" actId="1076"/>
          <ac:spMkLst>
            <pc:docMk/>
            <pc:sldMk cId="2105458467" sldId="2283"/>
            <ac:spMk id="22" creationId="{A1A6C24D-FECE-59DA-B996-8DFE9DE853F2}"/>
          </ac:spMkLst>
        </pc:spChg>
        <pc:spChg chg="mod">
          <ac:chgData name="Mareike Schell" userId="+hwTHCJ9DPY+RcXtlOoxeiHCh/r8M9NERwcOBswqpyo=" providerId="None" clId="Web-{2165B5CB-A405-40F9-9B6D-C976A6FD1273}" dt="2025-06-18T20:41:29.251" v="61" actId="1076"/>
          <ac:spMkLst>
            <pc:docMk/>
            <pc:sldMk cId="2105458467" sldId="2283"/>
            <ac:spMk id="23" creationId="{A42A442F-B98B-706D-6B50-F9D813670D0B}"/>
          </ac:spMkLst>
        </pc:spChg>
        <pc:spChg chg="mod">
          <ac:chgData name="Mareike Schell" userId="+hwTHCJ9DPY+RcXtlOoxeiHCh/r8M9NERwcOBswqpyo=" providerId="None" clId="Web-{2165B5CB-A405-40F9-9B6D-C976A6FD1273}" dt="2025-06-18T20:41:29.407" v="62" actId="1076"/>
          <ac:spMkLst>
            <pc:docMk/>
            <pc:sldMk cId="2105458467" sldId="2283"/>
            <ac:spMk id="24" creationId="{E16C5DE1-F2ED-1EB1-FF6C-08C5706DA404}"/>
          </ac:spMkLst>
        </pc:spChg>
        <pc:grpChg chg="mod">
          <ac:chgData name="Mareike Schell" userId="+hwTHCJ9DPY+RcXtlOoxeiHCh/r8M9NERwcOBswqpyo=" providerId="None" clId="Web-{2165B5CB-A405-40F9-9B6D-C976A6FD1273}" dt="2025-06-18T20:39:03.309" v="0" actId="1076"/>
          <ac:grpSpMkLst>
            <pc:docMk/>
            <pc:sldMk cId="2105458467" sldId="2283"/>
            <ac:grpSpMk id="6" creationId="{CC359C9F-7BC9-47CF-BEFC-0DA61A45203F}"/>
          </ac:grpSpMkLst>
        </pc:grpChg>
        <pc:picChg chg="mod">
          <ac:chgData name="Mareike Schell" userId="+hwTHCJ9DPY+RcXtlOoxeiHCh/r8M9NERwcOBswqpyo=" providerId="None" clId="Web-{2165B5CB-A405-40F9-9B6D-C976A6FD1273}" dt="2025-06-18T20:41:36.767" v="65" actId="1076"/>
          <ac:picMkLst>
            <pc:docMk/>
            <pc:sldMk cId="2105458467" sldId="2283"/>
            <ac:picMk id="18" creationId="{6E240840-1449-DA4C-6AC0-EB1FC169058B}"/>
          </ac:picMkLst>
        </pc:picChg>
        <pc:picChg chg="mod">
          <ac:chgData name="Mareike Schell" userId="+hwTHCJ9DPY+RcXtlOoxeiHCh/r8M9NERwcOBswqpyo=" providerId="None" clId="Web-{2165B5CB-A405-40F9-9B6D-C976A6FD1273}" dt="2025-06-18T20:39:30.638" v="8" actId="1076"/>
          <ac:picMkLst>
            <pc:docMk/>
            <pc:sldMk cId="2105458467" sldId="2283"/>
            <ac:picMk id="25" creationId="{893FF338-FEF2-3D63-8B17-F48584EFABB2}"/>
          </ac:picMkLst>
        </pc:picChg>
        <pc:picChg chg="mod">
          <ac:chgData name="Mareike Schell" userId="+hwTHCJ9DPY+RcXtlOoxeiHCh/r8M9NERwcOBswqpyo=" providerId="None" clId="Web-{2165B5CB-A405-40F9-9B6D-C976A6FD1273}" dt="2025-06-18T20:41:41.642" v="67" actId="1076"/>
          <ac:picMkLst>
            <pc:docMk/>
            <pc:sldMk cId="2105458467" sldId="2283"/>
            <ac:picMk id="26" creationId="{EFB16A03-E386-547F-FCE8-9303B0799495}"/>
          </ac:picMkLst>
        </pc:picChg>
        <pc:picChg chg="mod">
          <ac:chgData name="Mareike Schell" userId="+hwTHCJ9DPY+RcXtlOoxeiHCh/r8M9NERwcOBswqpyo=" providerId="None" clId="Web-{2165B5CB-A405-40F9-9B6D-C976A6FD1273}" dt="2025-06-18T20:41:36.861" v="66" actId="1076"/>
          <ac:picMkLst>
            <pc:docMk/>
            <pc:sldMk cId="2105458467" sldId="2283"/>
            <ac:picMk id="27" creationId="{076030E0-19B1-1657-571D-19A6133B904D}"/>
          </ac:picMkLst>
        </pc:picChg>
        <pc:cxnChg chg="add del mod">
          <ac:chgData name="Mareike Schell" userId="+hwTHCJ9DPY+RcXtlOoxeiHCh/r8M9NERwcOBswqpyo=" providerId="None" clId="Web-{2165B5CB-A405-40F9-9B6D-C976A6FD1273}" dt="2025-06-18T20:41:44.502" v="68"/>
          <ac:cxnSpMkLst>
            <pc:docMk/>
            <pc:sldMk cId="2105458467" sldId="2283"/>
            <ac:cxnSpMk id="30" creationId="{A775A2B3-A78C-99EB-06CE-E35072B4883E}"/>
          </ac:cxnSpMkLst>
        </pc:cxn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66" tIns="46584" rIns="93166" bIns="46584" rtlCol="0"/>
          <a:lstStyle>
            <a:lvl1pPr algn="r">
              <a:defRPr sz="1200"/>
            </a:lvl1pPr>
          </a:lstStyle>
          <a:p>
            <a:fld id="{B8E76031-5083-42A3-AEB2-84104042EB62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28863" y="1162050"/>
            <a:ext cx="2352675" cy="31384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66" tIns="46584" rIns="93166" bIns="4658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9"/>
          </a:xfrm>
          <a:prstGeom prst="rect">
            <a:avLst/>
          </a:prstGeom>
        </p:spPr>
        <p:txBody>
          <a:bodyPr vert="horz" lIns="93166" tIns="46584" rIns="93166" bIns="46584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9"/>
            <a:ext cx="3037840" cy="466433"/>
          </a:xfrm>
          <a:prstGeom prst="rect">
            <a:avLst/>
          </a:prstGeom>
        </p:spPr>
        <p:txBody>
          <a:bodyPr vert="horz" lIns="93166" tIns="46584" rIns="93166" bIns="46584" rtlCol="0" anchor="b"/>
          <a:lstStyle>
            <a:lvl1pPr algn="r">
              <a:defRPr sz="1200"/>
            </a:lvl1pPr>
          </a:lstStyle>
          <a:p>
            <a:fld id="{716B66B5-9926-446B-9214-7B7D28BAF47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23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28863" y="1162050"/>
            <a:ext cx="2352675" cy="3138488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16B66B5-9926-446B-9214-7B7D28BAF47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4550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819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74758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15088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511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564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2599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807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248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3368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2463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65872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BA8459-7E93-4F1B-BD53-910F08855FC0}" type="datetimeFigureOut">
              <a:rPr lang="en-US" smtClean="0"/>
              <a:t>7/2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39EBF0-3826-4DA2-A596-1E932E6BEC4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614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5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4.emf"/><Relationship Id="rId2" Type="http://schemas.openxmlformats.org/officeDocument/2006/relationships/notesSlide" Target="../notesSlides/notesSlide1.xml"/><Relationship Id="rId16" Type="http://schemas.openxmlformats.org/officeDocument/2006/relationships/oleObject" Target="../embeddings/oleObject1.bin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7" name="Group 136">
            <a:extLst>
              <a:ext uri="{FF2B5EF4-FFF2-40B4-BE49-F238E27FC236}">
                <a16:creationId xmlns:a16="http://schemas.microsoft.com/office/drawing/2014/main" id="{D66CA30F-78C6-C745-B777-DA22C854511A}"/>
              </a:ext>
            </a:extLst>
          </p:cNvPr>
          <p:cNvGrpSpPr/>
          <p:nvPr/>
        </p:nvGrpSpPr>
        <p:grpSpPr>
          <a:xfrm>
            <a:off x="238897" y="5669376"/>
            <a:ext cx="3735151" cy="1355271"/>
            <a:chOff x="238897" y="5063873"/>
            <a:chExt cx="3735151" cy="1355271"/>
          </a:xfrm>
        </p:grpSpPr>
        <p:grpSp>
          <p:nvGrpSpPr>
            <p:cNvPr id="118" name="Group 117">
              <a:extLst>
                <a:ext uri="{FF2B5EF4-FFF2-40B4-BE49-F238E27FC236}">
                  <a16:creationId xmlns:a16="http://schemas.microsoft.com/office/drawing/2014/main" id="{B7B12481-6A07-6AF1-3974-D351344B8FD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316448" y="5197605"/>
              <a:ext cx="3657600" cy="1221539"/>
              <a:chOff x="274635" y="5205760"/>
              <a:chExt cx="3735296" cy="1247487"/>
            </a:xfrm>
          </p:grpSpPr>
          <p:pic>
            <p:nvPicPr>
              <p:cNvPr id="34" name="Picture 33" descr="A green footprint on a white background&#10;&#10;Description automatically generated">
                <a:extLst>
                  <a:ext uri="{FF2B5EF4-FFF2-40B4-BE49-F238E27FC236}">
                    <a16:creationId xmlns:a16="http://schemas.microsoft.com/office/drawing/2014/main" id="{A8D7C0B5-8E80-CF14-E620-20E22FE21CE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 cstate="hq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7669" y="5205760"/>
                <a:ext cx="3662262" cy="1220754"/>
              </a:xfrm>
              <a:prstGeom prst="rect">
                <a:avLst/>
              </a:prstGeom>
            </p:spPr>
          </p:pic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id="{74C04F76-6924-AAA5-0D08-2CAF4702650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42582" y="5904046"/>
                <a:ext cx="0" cy="389123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>
                <a:extLst>
                  <a:ext uri="{FF2B5EF4-FFF2-40B4-BE49-F238E27FC236}">
                    <a16:creationId xmlns:a16="http://schemas.microsoft.com/office/drawing/2014/main" id="{F4140D36-DB4F-8C81-5E43-602D2DBAA2FE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433881" y="6279716"/>
                <a:ext cx="457459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4228AB05-70AB-3068-A2E5-C7DD180F2B6E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52332" y="6283970"/>
                <a:ext cx="536820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UMAP 1</a:t>
                </a:r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D1AF6B8D-708C-61BC-4B3D-B2B6C2DCEB74}"/>
                  </a:ext>
                </a:extLst>
              </p:cNvPr>
              <p:cNvSpPr txBox="1">
                <a:spLocks/>
              </p:cNvSpPr>
              <p:nvPr/>
            </p:nvSpPr>
            <p:spPr>
              <a:xfrm rot="16200000">
                <a:off x="82502" y="5963917"/>
                <a:ext cx="557095" cy="172830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UMAP 2</a:t>
                </a:r>
              </a:p>
            </p:txBody>
          </p:sp>
          <p:sp>
            <p:nvSpPr>
              <p:cNvPr id="39" name="TextBox 38">
                <a:extLst>
                  <a:ext uri="{FF2B5EF4-FFF2-40B4-BE49-F238E27FC236}">
                    <a16:creationId xmlns:a16="http://schemas.microsoft.com/office/drawing/2014/main" id="{6BF2315E-B8C0-7C81-D2EA-5CE646D6ABB5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736166" y="5210988"/>
                <a:ext cx="191488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1</a:t>
                </a:r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EAF2EF1C-C6FC-6A2A-A1D7-93F88D8A8EF9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870161" y="5213934"/>
                <a:ext cx="31096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G2M</a:t>
                </a:r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CA518D31-CF2F-13C5-6A9C-09BA9E62BB11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165011" y="5215241"/>
                <a:ext cx="96563" cy="1692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S</a:t>
                </a:r>
              </a:p>
            </p:txBody>
          </p:sp>
        </p:grpSp>
        <p:sp>
          <p:nvSpPr>
            <p:cNvPr id="99" name="TextBox 98">
              <a:extLst>
                <a:ext uri="{FF2B5EF4-FFF2-40B4-BE49-F238E27FC236}">
                  <a16:creationId xmlns:a16="http://schemas.microsoft.com/office/drawing/2014/main" id="{3FBB7238-2D8A-A594-5405-6DB05C003C98}"/>
                </a:ext>
              </a:extLst>
            </p:cNvPr>
            <p:cNvSpPr txBox="1">
              <a:spLocks/>
            </p:cNvSpPr>
            <p:nvPr/>
          </p:nvSpPr>
          <p:spPr>
            <a:xfrm>
              <a:off x="238897" y="5063873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4D98945E-CED4-AA02-C929-A0F901977099}"/>
              </a:ext>
            </a:extLst>
          </p:cNvPr>
          <p:cNvSpPr txBox="1"/>
          <p:nvPr/>
        </p:nvSpPr>
        <p:spPr>
          <a:xfrm>
            <a:off x="433558" y="4157332"/>
            <a:ext cx="99742" cy="179536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l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0" name="Picture 19" descr="A purple and white blot&#10;&#10;Description automatically generated">
            <a:extLst>
              <a:ext uri="{FF2B5EF4-FFF2-40B4-BE49-F238E27FC236}">
                <a16:creationId xmlns:a16="http://schemas.microsoft.com/office/drawing/2014/main" id="{3469A907-43D4-F513-CF2C-92D9798F454F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5689" y="3841277"/>
            <a:ext cx="1120140" cy="1120139"/>
          </a:xfrm>
          <a:prstGeom prst="rect">
            <a:avLst/>
          </a:prstGeom>
        </p:spPr>
      </p:pic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7A4D839-E9C7-443A-D304-5D1E83A160C7}"/>
              </a:ext>
            </a:extLst>
          </p:cNvPr>
          <p:cNvCxnSpPr>
            <a:cxnSpLocks/>
          </p:cNvCxnSpPr>
          <p:nvPr/>
        </p:nvCxnSpPr>
        <p:spPr>
          <a:xfrm>
            <a:off x="487642" y="4521241"/>
            <a:ext cx="0" cy="3570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FCCB099C-493F-7944-4587-F5A8A69D403D}"/>
              </a:ext>
            </a:extLst>
          </p:cNvPr>
          <p:cNvCxnSpPr>
            <a:cxnSpLocks/>
          </p:cNvCxnSpPr>
          <p:nvPr/>
        </p:nvCxnSpPr>
        <p:spPr>
          <a:xfrm>
            <a:off x="479183" y="4886476"/>
            <a:ext cx="43561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EBE6CFCF-AF3D-5B2B-F0CD-78D1A5ADC253}"/>
              </a:ext>
            </a:extLst>
          </p:cNvPr>
          <p:cNvSpPr txBox="1">
            <a:spLocks/>
          </p:cNvSpPr>
          <p:nvPr/>
        </p:nvSpPr>
        <p:spPr>
          <a:xfrm>
            <a:off x="497121" y="4890612"/>
            <a:ext cx="511180" cy="164575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MAP 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8EB79DD-EC15-3CD3-7EE1-19596799AB95}"/>
              </a:ext>
            </a:extLst>
          </p:cNvPr>
          <p:cNvSpPr txBox="1">
            <a:spLocks/>
          </p:cNvSpPr>
          <p:nvPr/>
        </p:nvSpPr>
        <p:spPr>
          <a:xfrm rot="16200000">
            <a:off x="136725" y="4558600"/>
            <a:ext cx="539845" cy="164575"/>
          </a:xfrm>
          <a:prstGeom prst="rect">
            <a:avLst/>
          </a:prstGeom>
          <a:noFill/>
          <a:ln>
            <a:noFill/>
          </a:ln>
        </p:spPr>
        <p:txBody>
          <a:bodyPr wrap="squar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MAP 2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17D99F8-F1CE-6B0E-1C85-E72279195E71}"/>
              </a:ext>
            </a:extLst>
          </p:cNvPr>
          <p:cNvSpPr txBox="1">
            <a:spLocks/>
          </p:cNvSpPr>
          <p:nvPr/>
        </p:nvSpPr>
        <p:spPr>
          <a:xfrm>
            <a:off x="452930" y="3700600"/>
            <a:ext cx="759823" cy="369332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  of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</a:p>
        </p:txBody>
      </p:sp>
      <p:pic>
        <p:nvPicPr>
          <p:cNvPr id="26" name="Picture 25" descr="A blue and red dots&#10;&#10;Description automatically generated">
            <a:extLst>
              <a:ext uri="{FF2B5EF4-FFF2-40B4-BE49-F238E27FC236}">
                <a16:creationId xmlns:a16="http://schemas.microsoft.com/office/drawing/2014/main" id="{9A45869C-FED5-6F61-E4B3-32B64F7AC822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000"/>
          <a:stretch/>
        </p:blipFill>
        <p:spPr>
          <a:xfrm>
            <a:off x="2861820" y="3845049"/>
            <a:ext cx="1120140" cy="1120139"/>
          </a:xfrm>
          <a:prstGeom prst="rect">
            <a:avLst/>
          </a:prstGeom>
        </p:spPr>
      </p:pic>
      <p:pic>
        <p:nvPicPr>
          <p:cNvPr id="27" name="Picture 26" descr="A blue and red dots&#10;&#10;Description automatically generated">
            <a:extLst>
              <a:ext uri="{FF2B5EF4-FFF2-40B4-BE49-F238E27FC236}">
                <a16:creationId xmlns:a16="http://schemas.microsoft.com/office/drawing/2014/main" id="{CCEE4CA2-AA33-B060-BCFC-605AB92618A9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936"/>
          <a:stretch/>
        </p:blipFill>
        <p:spPr>
          <a:xfrm>
            <a:off x="1746178" y="3845427"/>
            <a:ext cx="1121573" cy="1120139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FF05DDBB-41AF-9FE1-F2FB-E70DDBFDB0E2}"/>
              </a:ext>
            </a:extLst>
          </p:cNvPr>
          <p:cNvSpPr txBox="1">
            <a:spLocks/>
          </p:cNvSpPr>
          <p:nvPr/>
        </p:nvSpPr>
        <p:spPr>
          <a:xfrm>
            <a:off x="2036487" y="3802982"/>
            <a:ext cx="305462" cy="164575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10D18473-62CF-612E-65AC-9108521F0C19}"/>
              </a:ext>
            </a:extLst>
          </p:cNvPr>
          <p:cNvSpPr txBox="1">
            <a:spLocks/>
          </p:cNvSpPr>
          <p:nvPr/>
        </p:nvSpPr>
        <p:spPr>
          <a:xfrm>
            <a:off x="3117286" y="3802982"/>
            <a:ext cx="319488" cy="164575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-KO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2D37C149-570D-1D07-3345-AEC5873CA7A2}"/>
              </a:ext>
            </a:extLst>
          </p:cNvPr>
          <p:cNvSpPr txBox="1">
            <a:spLocks/>
          </p:cNvSpPr>
          <p:nvPr/>
        </p:nvSpPr>
        <p:spPr>
          <a:xfrm>
            <a:off x="238897" y="3689789"/>
            <a:ext cx="12984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9" name="Picture 48" descr="A blue dots on a white background&#10;&#10;Description automatically generated">
            <a:extLst>
              <a:ext uri="{FF2B5EF4-FFF2-40B4-BE49-F238E27FC236}">
                <a16:creationId xmlns:a16="http://schemas.microsoft.com/office/drawing/2014/main" id="{2B273ED5-8766-01B3-CC24-B54B9FE1FB02}"/>
              </a:ext>
            </a:extLst>
          </p:cNvPr>
          <p:cNvPicPr>
            <a:picLocks noChangeAspect="1"/>
          </p:cNvPicPr>
          <p:nvPr/>
        </p:nvPicPr>
        <p:blipFill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2284" y="1854786"/>
            <a:ext cx="1116004" cy="1116005"/>
          </a:xfrm>
          <a:prstGeom prst="rect">
            <a:avLst/>
          </a:prstGeom>
        </p:spPr>
      </p:pic>
      <p:pic>
        <p:nvPicPr>
          <p:cNvPr id="50" name="Picture 49" descr="A orange dots on a white background&#10;&#10;Description automatically generated">
            <a:extLst>
              <a:ext uri="{FF2B5EF4-FFF2-40B4-BE49-F238E27FC236}">
                <a16:creationId xmlns:a16="http://schemas.microsoft.com/office/drawing/2014/main" id="{9AC59A36-2D6D-06F5-27EB-863FB04D5B81}"/>
              </a:ext>
            </a:extLst>
          </p:cNvPr>
          <p:cNvPicPr>
            <a:picLocks noChangeAspect="1"/>
          </p:cNvPicPr>
          <p:nvPr/>
        </p:nvPicPr>
        <p:blipFill>
          <a:blip r:embed="rId7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9729" y="1859525"/>
            <a:ext cx="1116004" cy="1116005"/>
          </a:xfrm>
          <a:prstGeom prst="rect">
            <a:avLst/>
          </a:prstGeom>
        </p:spPr>
      </p:pic>
      <p:pic>
        <p:nvPicPr>
          <p:cNvPr id="51" name="Picture 50" descr="A blue dots on a white background&#10;&#10;Description automatically generated">
            <a:extLst>
              <a:ext uri="{FF2B5EF4-FFF2-40B4-BE49-F238E27FC236}">
                <a16:creationId xmlns:a16="http://schemas.microsoft.com/office/drawing/2014/main" id="{88DB4EC8-CF9E-B20E-B9B2-6259F9F6CC9E}"/>
              </a:ext>
            </a:extLst>
          </p:cNvPr>
          <p:cNvPicPr>
            <a:picLocks noChangeAspect="1"/>
          </p:cNvPicPr>
          <p:nvPr/>
        </p:nvPicPr>
        <p:blipFill>
          <a:blip r:embed="rId8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537" y="1861278"/>
            <a:ext cx="1116004" cy="1116005"/>
          </a:xfrm>
          <a:prstGeom prst="rect">
            <a:avLst/>
          </a:prstGeom>
        </p:spPr>
      </p:pic>
      <p:pic>
        <p:nvPicPr>
          <p:cNvPr id="52" name="Picture 51" descr="A green dot pattern on a white background&#10;&#10;Description automatically generated">
            <a:extLst>
              <a:ext uri="{FF2B5EF4-FFF2-40B4-BE49-F238E27FC236}">
                <a16:creationId xmlns:a16="http://schemas.microsoft.com/office/drawing/2014/main" id="{6FF86AC5-1F4E-B985-CD75-6A0DAD3C114C}"/>
              </a:ext>
            </a:extLst>
          </p:cNvPr>
          <p:cNvPicPr>
            <a:picLocks noChangeAspect="1"/>
          </p:cNvPicPr>
          <p:nvPr/>
        </p:nvPicPr>
        <p:blipFill>
          <a:blip r:embed="rId9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7329" y="1859525"/>
            <a:ext cx="1116004" cy="1116005"/>
          </a:xfrm>
          <a:prstGeom prst="rect">
            <a:avLst/>
          </a:prstGeom>
        </p:spPr>
      </p:pic>
      <p:pic>
        <p:nvPicPr>
          <p:cNvPr id="53" name="Picture 52" descr="A yellow dot pattern on a white background&#10;&#10;Description automatically generated">
            <a:extLst>
              <a:ext uri="{FF2B5EF4-FFF2-40B4-BE49-F238E27FC236}">
                <a16:creationId xmlns:a16="http://schemas.microsoft.com/office/drawing/2014/main" id="{D0BC771B-C4CC-6979-D36F-B15B4C3B8BA8}"/>
              </a:ext>
            </a:extLst>
          </p:cNvPr>
          <p:cNvPicPr>
            <a:picLocks noChangeAspect="1"/>
          </p:cNvPicPr>
          <p:nvPr/>
        </p:nvPicPr>
        <p:blipFill>
          <a:blip r:embed="rId10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3938" y="1854786"/>
            <a:ext cx="1116004" cy="1116005"/>
          </a:xfrm>
          <a:prstGeom prst="rect">
            <a:avLst/>
          </a:prstGeom>
        </p:spPr>
      </p:pic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82B1F4DE-0789-CAC6-1B5F-B4DF0CE59768}"/>
              </a:ext>
            </a:extLst>
          </p:cNvPr>
          <p:cNvCxnSpPr>
            <a:cxnSpLocks/>
          </p:cNvCxnSpPr>
          <p:nvPr/>
        </p:nvCxnSpPr>
        <p:spPr>
          <a:xfrm>
            <a:off x="493047" y="2543910"/>
            <a:ext cx="0" cy="3557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1" name="Straight Connector 90">
            <a:extLst>
              <a:ext uri="{FF2B5EF4-FFF2-40B4-BE49-F238E27FC236}">
                <a16:creationId xmlns:a16="http://schemas.microsoft.com/office/drawing/2014/main" id="{F4655D78-79BF-B4BD-9626-3F010EB9C101}"/>
              </a:ext>
            </a:extLst>
          </p:cNvPr>
          <p:cNvCxnSpPr>
            <a:cxnSpLocks/>
          </p:cNvCxnSpPr>
          <p:nvPr/>
        </p:nvCxnSpPr>
        <p:spPr>
          <a:xfrm>
            <a:off x="484619" y="2907796"/>
            <a:ext cx="43400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2" name="TextBox 91">
            <a:extLst>
              <a:ext uri="{FF2B5EF4-FFF2-40B4-BE49-F238E27FC236}">
                <a16:creationId xmlns:a16="http://schemas.microsoft.com/office/drawing/2014/main" id="{8D399C7E-50D0-138C-CD5A-3D6FBC902CCA}"/>
              </a:ext>
            </a:extLst>
          </p:cNvPr>
          <p:cNvSpPr txBox="1">
            <a:spLocks/>
          </p:cNvSpPr>
          <p:nvPr/>
        </p:nvSpPr>
        <p:spPr>
          <a:xfrm>
            <a:off x="502491" y="2911917"/>
            <a:ext cx="509293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MAP 1</a:t>
            </a: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8349AEEE-3323-C840-A3F0-CF2281982077}"/>
              </a:ext>
            </a:extLst>
          </p:cNvPr>
          <p:cNvSpPr txBox="1">
            <a:spLocks/>
          </p:cNvSpPr>
          <p:nvPr/>
        </p:nvSpPr>
        <p:spPr>
          <a:xfrm rot="16200000">
            <a:off x="157705" y="2588463"/>
            <a:ext cx="509293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MAP 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0799D50-5179-0938-9ABB-8A00FD433BFD}"/>
              </a:ext>
            </a:extLst>
          </p:cNvPr>
          <p:cNvSpPr txBox="1">
            <a:spLocks/>
          </p:cNvSpPr>
          <p:nvPr/>
        </p:nvSpPr>
        <p:spPr>
          <a:xfrm>
            <a:off x="664406" y="1831164"/>
            <a:ext cx="431657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-KO 1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8F56C160-259A-0EAA-D411-FCEC528C901E}"/>
              </a:ext>
            </a:extLst>
          </p:cNvPr>
          <p:cNvSpPr txBox="1">
            <a:spLocks/>
          </p:cNvSpPr>
          <p:nvPr/>
        </p:nvSpPr>
        <p:spPr>
          <a:xfrm>
            <a:off x="5633023" y="1833034"/>
            <a:ext cx="431657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-KO 5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B5D608B1-1B69-3837-31CF-9B163BEA7EE7}"/>
              </a:ext>
            </a:extLst>
          </p:cNvPr>
          <p:cNvSpPr txBox="1">
            <a:spLocks/>
          </p:cNvSpPr>
          <p:nvPr/>
        </p:nvSpPr>
        <p:spPr>
          <a:xfrm>
            <a:off x="3076770" y="1833033"/>
            <a:ext cx="431657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-KO 3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EB7B8790-36FA-973F-F64C-3833FE73D157}"/>
              </a:ext>
            </a:extLst>
          </p:cNvPr>
          <p:cNvSpPr txBox="1">
            <a:spLocks/>
          </p:cNvSpPr>
          <p:nvPr/>
        </p:nvSpPr>
        <p:spPr>
          <a:xfrm>
            <a:off x="1923843" y="1834902"/>
            <a:ext cx="431657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-KO 2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4C365927-6B50-D9AB-8FA5-81A5630950BA}"/>
              </a:ext>
            </a:extLst>
          </p:cNvPr>
          <p:cNvSpPr txBox="1">
            <a:spLocks/>
          </p:cNvSpPr>
          <p:nvPr/>
        </p:nvSpPr>
        <p:spPr>
          <a:xfrm>
            <a:off x="4370353" y="1837144"/>
            <a:ext cx="431657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L-KO 4</a:t>
            </a:r>
          </a:p>
        </p:txBody>
      </p:sp>
      <p:pic>
        <p:nvPicPr>
          <p:cNvPr id="44" name="Picture 43" descr="A blue dot pattern on a white background&#10;&#10;Description automatically generated">
            <a:extLst>
              <a:ext uri="{FF2B5EF4-FFF2-40B4-BE49-F238E27FC236}">
                <a16:creationId xmlns:a16="http://schemas.microsoft.com/office/drawing/2014/main" id="{7CCB22C7-85CB-22F1-580B-34EEA20D0794}"/>
              </a:ext>
            </a:extLst>
          </p:cNvPr>
          <p:cNvPicPr>
            <a:picLocks noChangeAspect="1"/>
          </p:cNvPicPr>
          <p:nvPr/>
        </p:nvPicPr>
        <p:blipFill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41973" y="565805"/>
            <a:ext cx="1116004" cy="1116005"/>
          </a:xfrm>
          <a:prstGeom prst="rect">
            <a:avLst/>
          </a:prstGeom>
        </p:spPr>
      </p:pic>
      <p:pic>
        <p:nvPicPr>
          <p:cNvPr id="45" name="Picture 44" descr="A green dot pattern on a white background&#10;&#10;Description automatically generated">
            <a:extLst>
              <a:ext uri="{FF2B5EF4-FFF2-40B4-BE49-F238E27FC236}">
                <a16:creationId xmlns:a16="http://schemas.microsoft.com/office/drawing/2014/main" id="{F0DCB791-B5CC-B438-2BF3-7A94BEE30CE2}"/>
              </a:ext>
            </a:extLst>
          </p:cNvPr>
          <p:cNvPicPr>
            <a:picLocks noChangeAspect="1"/>
          </p:cNvPicPr>
          <p:nvPr/>
        </p:nvPicPr>
        <p:blipFill>
          <a:blip r:embed="rId1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54313" y="565805"/>
            <a:ext cx="1116004" cy="1116005"/>
          </a:xfrm>
          <a:prstGeom prst="rect">
            <a:avLst/>
          </a:prstGeom>
        </p:spPr>
      </p:pic>
      <p:pic>
        <p:nvPicPr>
          <p:cNvPr id="46" name="Picture 45" descr="A close up of a map&#10;&#10;Description automatically generated with medium confidence">
            <a:extLst>
              <a:ext uri="{FF2B5EF4-FFF2-40B4-BE49-F238E27FC236}">
                <a16:creationId xmlns:a16="http://schemas.microsoft.com/office/drawing/2014/main" id="{45D6E541-829A-938A-57FC-216F7F78C768}"/>
              </a:ext>
            </a:extLst>
          </p:cNvPr>
          <p:cNvPicPr>
            <a:picLocks noChangeAspect="1"/>
          </p:cNvPicPr>
          <p:nvPr/>
        </p:nvPicPr>
        <p:blipFill>
          <a:blip r:embed="rId1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5234" y="565805"/>
            <a:ext cx="1116004" cy="1116005"/>
          </a:xfrm>
          <a:prstGeom prst="rect">
            <a:avLst/>
          </a:prstGeom>
        </p:spPr>
      </p:pic>
      <p:pic>
        <p:nvPicPr>
          <p:cNvPr id="47" name="Picture 46" descr="A blue and white dotted pattern&#10;&#10;Description automatically generated with medium confidence">
            <a:extLst>
              <a:ext uri="{FF2B5EF4-FFF2-40B4-BE49-F238E27FC236}">
                <a16:creationId xmlns:a16="http://schemas.microsoft.com/office/drawing/2014/main" id="{D865E107-E8E0-86FE-E827-9C7770755CBE}"/>
              </a:ext>
            </a:extLst>
          </p:cNvPr>
          <p:cNvPicPr>
            <a:picLocks noChangeAspect="1"/>
          </p:cNvPicPr>
          <p:nvPr/>
        </p:nvPicPr>
        <p:blipFill>
          <a:blip r:embed="rId1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5776" y="565805"/>
            <a:ext cx="1116004" cy="1116005"/>
          </a:xfrm>
          <a:prstGeom prst="rect">
            <a:avLst/>
          </a:prstGeom>
        </p:spPr>
      </p:pic>
      <p:pic>
        <p:nvPicPr>
          <p:cNvPr id="48" name="Picture 47" descr="A yellow dots on a white background&#10;&#10;Description automatically generated">
            <a:extLst>
              <a:ext uri="{FF2B5EF4-FFF2-40B4-BE49-F238E27FC236}">
                <a16:creationId xmlns:a16="http://schemas.microsoft.com/office/drawing/2014/main" id="{6EE51EEB-7EA0-56CB-5BBE-0434AA083FB9}"/>
              </a:ext>
            </a:extLst>
          </p:cNvPr>
          <p:cNvPicPr>
            <a:picLocks noChangeAspect="1"/>
          </p:cNvPicPr>
          <p:nvPr/>
        </p:nvPicPr>
        <p:blipFill>
          <a:blip r:embed="rId1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745" y="568198"/>
            <a:ext cx="1116004" cy="1116005"/>
          </a:xfrm>
          <a:prstGeom prst="rect">
            <a:avLst/>
          </a:prstGeom>
        </p:spPr>
      </p:pic>
      <p:cxnSp>
        <p:nvCxnSpPr>
          <p:cNvPr id="70" name="Straight Connector 69">
            <a:extLst>
              <a:ext uri="{FF2B5EF4-FFF2-40B4-BE49-F238E27FC236}">
                <a16:creationId xmlns:a16="http://schemas.microsoft.com/office/drawing/2014/main" id="{37986110-CE66-2B39-B11B-70D62E5FB82E}"/>
              </a:ext>
            </a:extLst>
          </p:cNvPr>
          <p:cNvCxnSpPr>
            <a:cxnSpLocks/>
          </p:cNvCxnSpPr>
          <p:nvPr/>
        </p:nvCxnSpPr>
        <p:spPr>
          <a:xfrm>
            <a:off x="505331" y="1245786"/>
            <a:ext cx="0" cy="355733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0C49F17E-0197-BB36-43BC-12C11DA26050}"/>
              </a:ext>
            </a:extLst>
          </p:cNvPr>
          <p:cNvCxnSpPr>
            <a:cxnSpLocks/>
          </p:cNvCxnSpPr>
          <p:nvPr/>
        </p:nvCxnSpPr>
        <p:spPr>
          <a:xfrm>
            <a:off x="496903" y="1609673"/>
            <a:ext cx="43400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962AE3A0-210D-F5DC-8A2F-552A722E2284}"/>
              </a:ext>
            </a:extLst>
          </p:cNvPr>
          <p:cNvSpPr txBox="1">
            <a:spLocks/>
          </p:cNvSpPr>
          <p:nvPr/>
        </p:nvSpPr>
        <p:spPr>
          <a:xfrm>
            <a:off x="514775" y="1613793"/>
            <a:ext cx="509293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MAP 1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587C3438-B4A6-67C1-622A-C47657BF4FE4}"/>
              </a:ext>
            </a:extLst>
          </p:cNvPr>
          <p:cNvSpPr txBox="1">
            <a:spLocks/>
          </p:cNvSpPr>
          <p:nvPr/>
        </p:nvSpPr>
        <p:spPr>
          <a:xfrm rot="16200000">
            <a:off x="169989" y="1290340"/>
            <a:ext cx="509293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UMAP 2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F089A6E2-B405-1534-CE5A-609F0E22383E}"/>
              </a:ext>
            </a:extLst>
          </p:cNvPr>
          <p:cNvSpPr txBox="1">
            <a:spLocks/>
          </p:cNvSpPr>
          <p:nvPr/>
        </p:nvSpPr>
        <p:spPr>
          <a:xfrm>
            <a:off x="675962" y="555027"/>
            <a:ext cx="417682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 1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7E28595-F0F7-78AC-A0A3-255101F3A9ED}"/>
              </a:ext>
            </a:extLst>
          </p:cNvPr>
          <p:cNvSpPr txBox="1">
            <a:spLocks/>
          </p:cNvSpPr>
          <p:nvPr/>
        </p:nvSpPr>
        <p:spPr>
          <a:xfrm>
            <a:off x="5644580" y="556896"/>
            <a:ext cx="417682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 5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7F001B1A-F241-2322-1724-054B07F8F16A}"/>
              </a:ext>
            </a:extLst>
          </p:cNvPr>
          <p:cNvSpPr txBox="1">
            <a:spLocks/>
          </p:cNvSpPr>
          <p:nvPr/>
        </p:nvSpPr>
        <p:spPr>
          <a:xfrm>
            <a:off x="3088327" y="556895"/>
            <a:ext cx="417682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 3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ECB79390-0B5C-9357-5130-67FBBC6F4408}"/>
              </a:ext>
            </a:extLst>
          </p:cNvPr>
          <p:cNvSpPr txBox="1">
            <a:spLocks/>
          </p:cNvSpPr>
          <p:nvPr/>
        </p:nvSpPr>
        <p:spPr>
          <a:xfrm>
            <a:off x="1935400" y="558765"/>
            <a:ext cx="417682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 2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8490E7E3-B450-3476-D143-749D6F3C9AC1}"/>
              </a:ext>
            </a:extLst>
          </p:cNvPr>
          <p:cNvSpPr txBox="1">
            <a:spLocks/>
          </p:cNvSpPr>
          <p:nvPr/>
        </p:nvSpPr>
        <p:spPr>
          <a:xfrm>
            <a:off x="4381910" y="561006"/>
            <a:ext cx="417682" cy="163967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N 4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174E3E88-3800-7243-D6A2-12C1978CFDD7}"/>
              </a:ext>
            </a:extLst>
          </p:cNvPr>
          <p:cNvSpPr txBox="1">
            <a:spLocks/>
          </p:cNvSpPr>
          <p:nvPr/>
        </p:nvSpPr>
        <p:spPr>
          <a:xfrm>
            <a:off x="245117" y="412426"/>
            <a:ext cx="129844" cy="215444"/>
          </a:xfrm>
          <a:prstGeom prst="rect">
            <a:avLst/>
          </a:prstGeom>
          <a:noFill/>
          <a:ln>
            <a:noFill/>
          </a:ln>
        </p:spPr>
        <p:txBody>
          <a:bodyPr wrap="none" lIns="0" tIns="0" rIns="0" bIns="0" rtlCol="0">
            <a:spAutoFit/>
          </a:bodyPr>
          <a:lstStyle/>
          <a:p>
            <a:pPr algn="l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138" name="Group 137">
            <a:extLst>
              <a:ext uri="{FF2B5EF4-FFF2-40B4-BE49-F238E27FC236}">
                <a16:creationId xmlns:a16="http://schemas.microsoft.com/office/drawing/2014/main" id="{68BAD0D0-BD11-A359-75AC-F658C2DE6855}"/>
              </a:ext>
            </a:extLst>
          </p:cNvPr>
          <p:cNvGrpSpPr/>
          <p:nvPr/>
        </p:nvGrpSpPr>
        <p:grpSpPr>
          <a:xfrm>
            <a:off x="232677" y="7638553"/>
            <a:ext cx="4136123" cy="1393675"/>
            <a:chOff x="232677" y="6637070"/>
            <a:chExt cx="4136123" cy="1393675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39E3A840-FBF0-A0D0-2B07-4C114A10525A}"/>
                </a:ext>
              </a:extLst>
            </p:cNvPr>
            <p:cNvSpPr txBox="1">
              <a:spLocks/>
            </p:cNvSpPr>
            <p:nvPr/>
          </p:nvSpPr>
          <p:spPr>
            <a:xfrm>
              <a:off x="232677" y="6637070"/>
              <a:ext cx="120226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</a:p>
          </p:txBody>
        </p:sp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91374CE6-740A-2EED-FFFA-FAA762C02192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944283341"/>
                </p:ext>
              </p:extLst>
            </p:nvPr>
          </p:nvGraphicFramePr>
          <p:xfrm>
            <a:off x="314325" y="6668670"/>
            <a:ext cx="4054475" cy="1362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10" r:id="rId16" imgW="4053688" imgH="1362778" progId="Prism10.Document">
                    <p:embed/>
                  </p:oleObj>
                </mc:Choice>
                <mc:Fallback>
                  <p:oleObj name="Prism 10" r:id="rId16" imgW="4053688" imgH="1362778" progId="Prism10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91374CE6-740A-2EED-FFFA-FAA762C0219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314325" y="6668670"/>
                          <a:ext cx="4054475" cy="1362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21CB6B5A-ADF4-6F4D-A52A-BB10B33E2DCA}"/>
              </a:ext>
            </a:extLst>
          </p:cNvPr>
          <p:cNvSpPr txBox="1"/>
          <p:nvPr/>
        </p:nvSpPr>
        <p:spPr>
          <a:xfrm>
            <a:off x="6110590" y="8416902"/>
            <a:ext cx="58381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ON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5136C12-E970-8720-5A3A-AABB0BFE0E1F}"/>
              </a:ext>
            </a:extLst>
          </p:cNvPr>
          <p:cNvSpPr txBox="1"/>
          <p:nvPr/>
        </p:nvSpPr>
        <p:spPr>
          <a:xfrm>
            <a:off x="6110590" y="8633239"/>
            <a:ext cx="6222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L-KO</a:t>
            </a:r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E788675A-2E23-775E-13D7-7DF985BA8ED2}"/>
              </a:ext>
            </a:extLst>
          </p:cNvPr>
          <p:cNvSpPr/>
          <p:nvPr/>
        </p:nvSpPr>
        <p:spPr>
          <a:xfrm>
            <a:off x="5995137" y="8479350"/>
            <a:ext cx="182880" cy="18288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031307CF-0D2F-0780-7589-A6FD81DB9307}"/>
              </a:ext>
            </a:extLst>
          </p:cNvPr>
          <p:cNvSpPr/>
          <p:nvPr/>
        </p:nvSpPr>
        <p:spPr>
          <a:xfrm>
            <a:off x="5995137" y="8695687"/>
            <a:ext cx="182880" cy="182880"/>
          </a:xfrm>
          <a:prstGeom prst="rect">
            <a:avLst/>
          </a:prstGeom>
          <a:solidFill>
            <a:srgbClr val="8D8C8A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400"/>
          </a:p>
        </p:txBody>
      </p:sp>
      <p:grpSp>
        <p:nvGrpSpPr>
          <p:cNvPr id="140" name="Group 139">
            <a:extLst>
              <a:ext uri="{FF2B5EF4-FFF2-40B4-BE49-F238E27FC236}">
                <a16:creationId xmlns:a16="http://schemas.microsoft.com/office/drawing/2014/main" id="{8D6F3209-ED41-C2CE-34E6-2C669A38B09D}"/>
              </a:ext>
            </a:extLst>
          </p:cNvPr>
          <p:cNvGrpSpPr/>
          <p:nvPr/>
        </p:nvGrpSpPr>
        <p:grpSpPr>
          <a:xfrm>
            <a:off x="4073575" y="3695073"/>
            <a:ext cx="2651043" cy="4542565"/>
            <a:chOff x="3888375" y="3695073"/>
            <a:chExt cx="2651043" cy="4542565"/>
          </a:xfrm>
        </p:grpSpPr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9882F864-8510-40D3-C630-D0A6DBFB3E0B}"/>
                </a:ext>
              </a:extLst>
            </p:cNvPr>
            <p:cNvSpPr txBox="1">
              <a:spLocks/>
            </p:cNvSpPr>
            <p:nvPr/>
          </p:nvSpPr>
          <p:spPr>
            <a:xfrm>
              <a:off x="4090760" y="3695073"/>
              <a:ext cx="129844" cy="215444"/>
            </a:xfrm>
            <a:prstGeom prst="rect">
              <a:avLst/>
            </a:prstGeom>
            <a:noFill/>
            <a:ln>
              <a:noFill/>
            </a:ln>
          </p:spPr>
          <p:txBody>
            <a:bodyPr wrap="none" lIns="0" tIns="0" rIns="0" bIns="0" rtlCol="0">
              <a:spAutoFit/>
            </a:bodyPr>
            <a:lstStyle/>
            <a:p>
              <a:pPr algn="l"/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grpSp>
          <p:nvGrpSpPr>
            <p:cNvPr id="139" name="Group 138">
              <a:extLst>
                <a:ext uri="{FF2B5EF4-FFF2-40B4-BE49-F238E27FC236}">
                  <a16:creationId xmlns:a16="http://schemas.microsoft.com/office/drawing/2014/main" id="{FF267168-83B3-AD20-9FD3-8047302A6EE0}"/>
                </a:ext>
              </a:extLst>
            </p:cNvPr>
            <p:cNvGrpSpPr/>
            <p:nvPr/>
          </p:nvGrpSpPr>
          <p:grpSpPr>
            <a:xfrm>
              <a:off x="3888375" y="3786045"/>
              <a:ext cx="2651043" cy="4451593"/>
              <a:chOff x="3888375" y="3711405"/>
              <a:chExt cx="2651043" cy="4451593"/>
            </a:xfrm>
          </p:grpSpPr>
          <p:pic>
            <p:nvPicPr>
              <p:cNvPr id="7" name="Picture 6" descr="A screenshot of a graph&#10;&#10;Description automatically generated">
                <a:extLst>
                  <a:ext uri="{FF2B5EF4-FFF2-40B4-BE49-F238E27FC236}">
                    <a16:creationId xmlns:a16="http://schemas.microsoft.com/office/drawing/2014/main" id="{A9BCE4C8-F9A7-D92A-5100-93751E885D2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8" cstate="hqprint">
                <a:alphaModFix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047" t="452" r="33387" b="3070"/>
              <a:stretch>
                <a:fillRect/>
              </a:stretch>
            </p:blipFill>
            <p:spPr>
              <a:xfrm>
                <a:off x="5066226" y="3717006"/>
                <a:ext cx="900148" cy="3701851"/>
              </a:xfrm>
              <a:prstGeom prst="rect">
                <a:avLst/>
              </a:prstGeom>
            </p:spPr>
          </p:pic>
          <p:grpSp>
            <p:nvGrpSpPr>
              <p:cNvPr id="124" name="Group 123">
                <a:extLst>
                  <a:ext uri="{FF2B5EF4-FFF2-40B4-BE49-F238E27FC236}">
                    <a16:creationId xmlns:a16="http://schemas.microsoft.com/office/drawing/2014/main" id="{EE85FA1A-85AA-F9A4-6162-EB113B3A6D69}"/>
                  </a:ext>
                </a:extLst>
              </p:cNvPr>
              <p:cNvGrpSpPr/>
              <p:nvPr/>
            </p:nvGrpSpPr>
            <p:grpSpPr>
              <a:xfrm>
                <a:off x="3888375" y="3711405"/>
                <a:ext cx="2651043" cy="4451593"/>
                <a:chOff x="4004383" y="3711405"/>
                <a:chExt cx="2651043" cy="4451593"/>
              </a:xfrm>
            </p:grpSpPr>
            <p:sp>
              <p:nvSpPr>
                <p:cNvPr id="189" name="TextBox 188">
                  <a:extLst>
                    <a:ext uri="{FF2B5EF4-FFF2-40B4-BE49-F238E27FC236}">
                      <a16:creationId xmlns:a16="http://schemas.microsoft.com/office/drawing/2014/main" id="{DBE3D245-B6C8-1F2E-20B9-3302FEE000B3}"/>
                    </a:ext>
                  </a:extLst>
                </p:cNvPr>
                <p:cNvSpPr txBox="1"/>
                <p:nvPr/>
              </p:nvSpPr>
              <p:spPr>
                <a:xfrm rot="16200000">
                  <a:off x="5222250" y="7245702"/>
                  <a:ext cx="844576" cy="990015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 rtlCol="0">
                  <a:spAutoFit/>
                </a:bodyPr>
                <a:lstStyle/>
                <a:p>
                  <a:pPr algn="r">
                    <a:lnSpc>
                      <a:spcPts val="1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P1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P2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DO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OL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S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1</a:t>
                  </a:r>
                </a:p>
                <a:p>
                  <a:pPr algn="r">
                    <a:lnSpc>
                      <a:spcPts val="1000"/>
                    </a:lnSpc>
                  </a:pPr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2</a:t>
                  </a:r>
                </a:p>
              </p:txBody>
            </p:sp>
            <p:sp>
              <p:nvSpPr>
                <p:cNvPr id="190" name="TextBox 189">
                  <a:extLst>
                    <a:ext uri="{FF2B5EF4-FFF2-40B4-BE49-F238E27FC236}">
                      <a16:creationId xmlns:a16="http://schemas.microsoft.com/office/drawing/2014/main" id="{1427358D-B880-3C8A-E03D-D29BA068B271}"/>
                    </a:ext>
                  </a:extLst>
                </p:cNvPr>
                <p:cNvSpPr txBox="1"/>
                <p:nvPr/>
              </p:nvSpPr>
              <p:spPr>
                <a:xfrm>
                  <a:off x="6002061" y="3711405"/>
                  <a:ext cx="653365" cy="37891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lb 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Ttr</a:t>
                  </a:r>
                  <a:endParaRPr 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nf4a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ab1 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tab2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ve1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cgr2b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Flt4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Vwf</a:t>
                  </a:r>
                  <a:endParaRPr 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rt19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ox9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Epcam</a:t>
                  </a:r>
                  <a:endParaRPr 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Lrat</a:t>
                  </a:r>
                  <a:endParaRPr 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Reln</a:t>
                  </a:r>
                  <a:endParaRPr 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es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Dcn</a:t>
                  </a:r>
                  <a:endParaRPr 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yh11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nn1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fap4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l15a1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Thy1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f3r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100a8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d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3g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s4a1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79b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d19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cr1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Gzma</a:t>
                  </a:r>
                  <a:endParaRPr 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kg7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Itgax</a:t>
                  </a:r>
                  <a:endParaRPr lang="en-US" sz="1000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cr2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Ly6c2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dgre1</a:t>
                  </a:r>
                </a:p>
                <a:p>
                  <a:pPr>
                    <a:lnSpc>
                      <a:spcPts val="800"/>
                    </a:lnSpc>
                  </a:pPr>
                  <a:r>
                    <a:rPr lang="en-US" sz="1000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sf1r</a:t>
                  </a:r>
                </a:p>
              </p:txBody>
            </p:sp>
            <p:cxnSp>
              <p:nvCxnSpPr>
                <p:cNvPr id="8" name="Straight Connector 7">
                  <a:extLst>
                    <a:ext uri="{FF2B5EF4-FFF2-40B4-BE49-F238E27FC236}">
                      <a16:creationId xmlns:a16="http://schemas.microsoft.com/office/drawing/2014/main" id="{4A872082-FBDF-5947-D43A-9E8DA983A4A9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3748455"/>
                  <a:ext cx="0" cy="27432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" name="Straight Connector 13">
                  <a:extLst>
                    <a:ext uri="{FF2B5EF4-FFF2-40B4-BE49-F238E27FC236}">
                      <a16:creationId xmlns:a16="http://schemas.microsoft.com/office/drawing/2014/main" id="{AF1B503D-3BDD-B09C-A86F-B45E68CC316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4056187"/>
                  <a:ext cx="0" cy="47548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" name="Straight Connector 14">
                  <a:extLst>
                    <a:ext uri="{FF2B5EF4-FFF2-40B4-BE49-F238E27FC236}">
                      <a16:creationId xmlns:a16="http://schemas.microsoft.com/office/drawing/2014/main" id="{1B158E40-820D-5A86-BFE3-7BAAEBA92F6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455441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Straight Connector 15">
                  <a:extLst>
                    <a:ext uri="{FF2B5EF4-FFF2-40B4-BE49-F238E27FC236}">
                      <a16:creationId xmlns:a16="http://schemas.microsoft.com/office/drawing/2014/main" id="{8C65FCA0-6200-5E54-65C6-9D2DD28ECBB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4668716"/>
                  <a:ext cx="0" cy="27432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" name="Straight Connector 16">
                  <a:extLst>
                    <a:ext uri="{FF2B5EF4-FFF2-40B4-BE49-F238E27FC236}">
                      <a16:creationId xmlns:a16="http://schemas.microsoft.com/office/drawing/2014/main" id="{D0D9F09C-7653-3D2A-1A8E-A124B5904FF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5583117"/>
                  <a:ext cx="0" cy="27432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Straight Connector 17">
                  <a:extLst>
                    <a:ext uri="{FF2B5EF4-FFF2-40B4-BE49-F238E27FC236}">
                      <a16:creationId xmlns:a16="http://schemas.microsoft.com/office/drawing/2014/main" id="{D16796FC-4D30-5E43-9C92-1102606FEA0F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4970586"/>
                  <a:ext cx="0" cy="38404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Straight Connector 18">
                  <a:extLst>
                    <a:ext uri="{FF2B5EF4-FFF2-40B4-BE49-F238E27FC236}">
                      <a16:creationId xmlns:a16="http://schemas.microsoft.com/office/drawing/2014/main" id="{1CCF0122-C538-9047-DAC5-340495E9547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5375151"/>
                  <a:ext cx="0" cy="18288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2" name="Straight Connector 41">
                  <a:extLst>
                    <a:ext uri="{FF2B5EF4-FFF2-40B4-BE49-F238E27FC236}">
                      <a16:creationId xmlns:a16="http://schemas.microsoft.com/office/drawing/2014/main" id="{519E52BD-1015-8D57-9ACF-0DB03ED4CC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5882174"/>
                  <a:ext cx="0" cy="18288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3" name="Straight Connector 42">
                  <a:extLst>
                    <a:ext uri="{FF2B5EF4-FFF2-40B4-BE49-F238E27FC236}">
                      <a16:creationId xmlns:a16="http://schemas.microsoft.com/office/drawing/2014/main" id="{202D737D-4B8C-4A45-B97D-DB2A577622B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6087327"/>
                  <a:ext cx="0" cy="18288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4" name="Straight Connector 93">
                  <a:extLst>
                    <a:ext uri="{FF2B5EF4-FFF2-40B4-BE49-F238E27FC236}">
                      <a16:creationId xmlns:a16="http://schemas.microsoft.com/office/drawing/2014/main" id="{E00897AC-087F-3211-8F6F-54515FD1BFC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6295294"/>
                  <a:ext cx="0" cy="27432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5" name="Straight Connector 94">
                  <a:extLst>
                    <a:ext uri="{FF2B5EF4-FFF2-40B4-BE49-F238E27FC236}">
                      <a16:creationId xmlns:a16="http://schemas.microsoft.com/office/drawing/2014/main" id="{B4626A27-50FE-E877-CAA4-D83F33AD437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6597163"/>
                  <a:ext cx="0" cy="27432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Straight Connector 95">
                  <a:extLst>
                    <a:ext uri="{FF2B5EF4-FFF2-40B4-BE49-F238E27FC236}">
                      <a16:creationId xmlns:a16="http://schemas.microsoft.com/office/drawing/2014/main" id="{8C84C3FB-ADFA-61F5-ACB5-A0768A91EA0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7206882"/>
                  <a:ext cx="0" cy="18288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Straight Connector 96">
                  <a:extLst>
                    <a:ext uri="{FF2B5EF4-FFF2-40B4-BE49-F238E27FC236}">
                      <a16:creationId xmlns:a16="http://schemas.microsoft.com/office/drawing/2014/main" id="{3A58E866-02AF-9546-D0BA-855CEA6D03A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7001729"/>
                  <a:ext cx="0" cy="18288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3" name="Straight Connector 102">
                  <a:extLst>
                    <a:ext uri="{FF2B5EF4-FFF2-40B4-BE49-F238E27FC236}">
                      <a16:creationId xmlns:a16="http://schemas.microsoft.com/office/drawing/2014/main" id="{26E8056D-BAB5-1A2D-C69D-5C07AAABFA8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166987" y="6895634"/>
                  <a:ext cx="0" cy="9144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4" name="TextBox 103">
                  <a:extLst>
                    <a:ext uri="{FF2B5EF4-FFF2-40B4-BE49-F238E27FC236}">
                      <a16:creationId xmlns:a16="http://schemas.microsoft.com/office/drawing/2014/main" id="{06364082-24DF-1FC7-2C24-9477C1FF091F}"/>
                    </a:ext>
                  </a:extLst>
                </p:cNvPr>
                <p:cNvSpPr txBox="1"/>
                <p:nvPr/>
              </p:nvSpPr>
              <p:spPr>
                <a:xfrm>
                  <a:off x="4780845" y="3768850"/>
                  <a:ext cx="44755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EP</a:t>
                  </a:r>
                </a:p>
              </p:txBody>
            </p: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5DFF438A-B4F2-45B9-758A-86E628616BA8}"/>
                    </a:ext>
                  </a:extLst>
                </p:cNvPr>
                <p:cNvSpPr txBox="1"/>
                <p:nvPr/>
              </p:nvSpPr>
              <p:spPr>
                <a:xfrm>
                  <a:off x="4253456" y="4176118"/>
                  <a:ext cx="97494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DO(LSEC)</a:t>
                  </a:r>
                </a:p>
              </p:txBody>
            </p:sp>
            <p:sp>
              <p:nvSpPr>
                <p:cNvPr id="106" name="TextBox 105">
                  <a:extLst>
                    <a:ext uri="{FF2B5EF4-FFF2-40B4-BE49-F238E27FC236}">
                      <a16:creationId xmlns:a16="http://schemas.microsoft.com/office/drawing/2014/main" id="{CCE5A810-3B8A-7BE9-953F-C0CBD7E92678}"/>
                    </a:ext>
                  </a:extLst>
                </p:cNvPr>
                <p:cNvSpPr txBox="1"/>
                <p:nvPr/>
              </p:nvSpPr>
              <p:spPr>
                <a:xfrm>
                  <a:off x="4322776" y="4472349"/>
                  <a:ext cx="90441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ENDO(VEC)</a:t>
                  </a:r>
                </a:p>
              </p:txBody>
            </p:sp>
            <p:sp>
              <p:nvSpPr>
                <p:cNvPr id="107" name="TextBox 106">
                  <a:extLst>
                    <a:ext uri="{FF2B5EF4-FFF2-40B4-BE49-F238E27FC236}">
                      <a16:creationId xmlns:a16="http://schemas.microsoft.com/office/drawing/2014/main" id="{6C71BE2B-1B7B-85D0-B680-A28D822920F3}"/>
                    </a:ext>
                  </a:extLst>
                </p:cNvPr>
                <p:cNvSpPr txBox="1"/>
                <p:nvPr/>
              </p:nvSpPr>
              <p:spPr>
                <a:xfrm>
                  <a:off x="4686657" y="4677529"/>
                  <a:ext cx="54053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HOL</a:t>
                  </a:r>
                </a:p>
              </p:txBody>
            </p:sp>
            <p:sp>
              <p:nvSpPr>
                <p:cNvPr id="108" name="TextBox 107">
                  <a:extLst>
                    <a:ext uri="{FF2B5EF4-FFF2-40B4-BE49-F238E27FC236}">
                      <a16:creationId xmlns:a16="http://schemas.microsoft.com/office/drawing/2014/main" id="{6E79BE45-13A6-9DEA-58B9-57E7263430CD}"/>
                    </a:ext>
                  </a:extLst>
                </p:cNvPr>
                <p:cNvSpPr txBox="1"/>
                <p:nvPr/>
              </p:nvSpPr>
              <p:spPr>
                <a:xfrm>
                  <a:off x="4407734" y="5036296"/>
                  <a:ext cx="81945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S(HSC)</a:t>
                  </a:r>
                </a:p>
              </p:txBody>
            </p:sp>
            <p:sp>
              <p:nvSpPr>
                <p:cNvPr id="109" name="TextBox 108">
                  <a:extLst>
                    <a:ext uri="{FF2B5EF4-FFF2-40B4-BE49-F238E27FC236}">
                      <a16:creationId xmlns:a16="http://schemas.microsoft.com/office/drawing/2014/main" id="{35D5D8DC-F007-9274-19CA-C4FAFD0AD3D4}"/>
                    </a:ext>
                  </a:extLst>
                </p:cNvPr>
                <p:cNvSpPr txBox="1"/>
                <p:nvPr/>
              </p:nvSpPr>
              <p:spPr>
                <a:xfrm>
                  <a:off x="4308348" y="5345042"/>
                  <a:ext cx="918842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S(VSMC)</a:t>
                  </a:r>
                </a:p>
              </p:txBody>
            </p:sp>
            <p:sp>
              <p:nvSpPr>
                <p:cNvPr id="110" name="TextBox 109">
                  <a:extLst>
                    <a:ext uri="{FF2B5EF4-FFF2-40B4-BE49-F238E27FC236}">
                      <a16:creationId xmlns:a16="http://schemas.microsoft.com/office/drawing/2014/main" id="{B0C64AE9-F680-48FC-DD9B-F06E3F161587}"/>
                    </a:ext>
                  </a:extLst>
                </p:cNvPr>
                <p:cNvSpPr txBox="1"/>
                <p:nvPr/>
              </p:nvSpPr>
              <p:spPr>
                <a:xfrm>
                  <a:off x="4515136" y="5599190"/>
                  <a:ext cx="712054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S(PF)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EE82D907-2461-BFFA-D2B5-ABB7471A0BAC}"/>
                    </a:ext>
                  </a:extLst>
                </p:cNvPr>
                <p:cNvSpPr txBox="1"/>
                <p:nvPr/>
              </p:nvSpPr>
              <p:spPr>
                <a:xfrm>
                  <a:off x="4124609" y="5845480"/>
                  <a:ext cx="1103187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(Neutrophil)</a:t>
                  </a:r>
                </a:p>
              </p:txBody>
            </p:sp>
            <p:sp>
              <p:nvSpPr>
                <p:cNvPr id="112" name="TextBox 111">
                  <a:extLst>
                    <a:ext uri="{FF2B5EF4-FFF2-40B4-BE49-F238E27FC236}">
                      <a16:creationId xmlns:a16="http://schemas.microsoft.com/office/drawing/2014/main" id="{CA525C34-4DDE-A33A-46A2-637D841B5283}"/>
                    </a:ext>
                  </a:extLst>
                </p:cNvPr>
                <p:cNvSpPr txBox="1"/>
                <p:nvPr/>
              </p:nvSpPr>
              <p:spPr>
                <a:xfrm>
                  <a:off x="4361006" y="6054203"/>
                  <a:ext cx="8643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(T-Cell)</a:t>
                  </a:r>
                </a:p>
              </p:txBody>
            </p:sp>
            <p:sp>
              <p:nvSpPr>
                <p:cNvPr id="113" name="TextBox 112">
                  <a:extLst>
                    <a:ext uri="{FF2B5EF4-FFF2-40B4-BE49-F238E27FC236}">
                      <a16:creationId xmlns:a16="http://schemas.microsoft.com/office/drawing/2014/main" id="{39DC8BD4-F227-CB4C-D04E-8231FD03E423}"/>
                    </a:ext>
                  </a:extLst>
                </p:cNvPr>
                <p:cNvSpPr txBox="1"/>
                <p:nvPr/>
              </p:nvSpPr>
              <p:spPr>
                <a:xfrm>
                  <a:off x="4361006" y="6308039"/>
                  <a:ext cx="86434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(B-Cell)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A6AECCF9-DBDB-3289-601A-283F3BA9A2EC}"/>
                    </a:ext>
                  </a:extLst>
                </p:cNvPr>
                <p:cNvSpPr txBox="1"/>
                <p:nvPr/>
              </p:nvSpPr>
              <p:spPr>
                <a:xfrm>
                  <a:off x="4269635" y="6617097"/>
                  <a:ext cx="955711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(NK Cell)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729690EB-034A-11BC-158F-7354DB21EAA1}"/>
                    </a:ext>
                  </a:extLst>
                </p:cNvPr>
                <p:cNvSpPr txBox="1"/>
                <p:nvPr/>
              </p:nvSpPr>
              <p:spPr>
                <a:xfrm>
                  <a:off x="4518100" y="6817578"/>
                  <a:ext cx="70724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(DC)</a:t>
                  </a:r>
                </a:p>
              </p:txBody>
            </p:sp>
            <p:sp>
              <p:nvSpPr>
                <p:cNvPr id="116" name="TextBox 115">
                  <a:extLst>
                    <a:ext uri="{FF2B5EF4-FFF2-40B4-BE49-F238E27FC236}">
                      <a16:creationId xmlns:a16="http://schemas.microsoft.com/office/drawing/2014/main" id="{954B6B70-DD93-1DA3-BFF8-9CFA59EA10F8}"/>
                    </a:ext>
                  </a:extLst>
                </p:cNvPr>
                <p:cNvSpPr txBox="1"/>
                <p:nvPr/>
              </p:nvSpPr>
              <p:spPr>
                <a:xfrm>
                  <a:off x="4159875" y="6970058"/>
                  <a:ext cx="1074333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(Monocyte)</a:t>
                  </a:r>
                </a:p>
              </p:txBody>
            </p: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91FA33A3-633F-2A5A-2432-21B66FEBBFFD}"/>
                    </a:ext>
                  </a:extLst>
                </p:cNvPr>
                <p:cNvSpPr txBox="1"/>
                <p:nvPr/>
              </p:nvSpPr>
              <p:spPr>
                <a:xfrm>
                  <a:off x="4004383" y="7122458"/>
                  <a:ext cx="1229825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r"/>
                  <a:r>
                    <a:rPr lang="en-US" sz="10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MM(Macrophage)</a:t>
                  </a:r>
                </a:p>
              </p:txBody>
            </p:sp>
            <p:grpSp>
              <p:nvGrpSpPr>
                <p:cNvPr id="122" name="Group 121">
                  <a:extLst>
                    <a:ext uri="{FF2B5EF4-FFF2-40B4-BE49-F238E27FC236}">
                      <a16:creationId xmlns:a16="http://schemas.microsoft.com/office/drawing/2014/main" id="{46E54AA3-F68E-E8D9-3172-DDDAC09743AA}"/>
                    </a:ext>
                  </a:extLst>
                </p:cNvPr>
                <p:cNvGrpSpPr/>
                <p:nvPr/>
              </p:nvGrpSpPr>
              <p:grpSpPr>
                <a:xfrm>
                  <a:off x="5088779" y="7800626"/>
                  <a:ext cx="1085712" cy="344155"/>
                  <a:chOff x="5088779" y="8039162"/>
                  <a:chExt cx="1085712" cy="344155"/>
                </a:xfrm>
              </p:grpSpPr>
              <p:grpSp>
                <p:nvGrpSpPr>
                  <p:cNvPr id="181" name="Group 180">
                    <a:extLst>
                      <a:ext uri="{FF2B5EF4-FFF2-40B4-BE49-F238E27FC236}">
                        <a16:creationId xmlns:a16="http://schemas.microsoft.com/office/drawing/2014/main" id="{A84A980A-3F53-4F8F-6237-84D4C10F5904}"/>
                      </a:ext>
                    </a:extLst>
                  </p:cNvPr>
                  <p:cNvGrpSpPr/>
                  <p:nvPr/>
                </p:nvGrpSpPr>
                <p:grpSpPr>
                  <a:xfrm>
                    <a:off x="5088779" y="8116722"/>
                    <a:ext cx="1085712" cy="266595"/>
                    <a:chOff x="3766421" y="5991173"/>
                    <a:chExt cx="1085712" cy="266595"/>
                  </a:xfrm>
                </p:grpSpPr>
                <p:grpSp>
                  <p:nvGrpSpPr>
                    <p:cNvPr id="182" name="Group 181">
                      <a:extLst>
                        <a:ext uri="{FF2B5EF4-FFF2-40B4-BE49-F238E27FC236}">
                          <a16:creationId xmlns:a16="http://schemas.microsoft.com/office/drawing/2014/main" id="{12938D92-18C0-CE45-D49D-48498A0A6FDF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4185647" y="5591282"/>
                      <a:ext cx="247260" cy="1085712"/>
                      <a:chOff x="5220137" y="2578891"/>
                      <a:chExt cx="247260" cy="1085712"/>
                    </a:xfrm>
                  </p:grpSpPr>
                  <p:sp>
                    <p:nvSpPr>
                      <p:cNvPr id="185" name="TextBox 184">
                        <a:extLst>
                          <a:ext uri="{FF2B5EF4-FFF2-40B4-BE49-F238E27FC236}">
                            <a16:creationId xmlns:a16="http://schemas.microsoft.com/office/drawing/2014/main" id="{24F0FC61-F220-E2C9-19A1-A4088869EAFA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5162489" y="2636539"/>
                        <a:ext cx="361517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+2</a:t>
                        </a:r>
                      </a:p>
                    </p:txBody>
                  </p:sp>
                  <p:sp>
                    <p:nvSpPr>
                      <p:cNvPr id="186" name="TextBox 185">
                        <a:extLst>
                          <a:ext uri="{FF2B5EF4-FFF2-40B4-BE49-F238E27FC236}">
                            <a16:creationId xmlns:a16="http://schemas.microsoft.com/office/drawing/2014/main" id="{3ED31879-6C06-8BC7-640D-9C8047BB8B62}"/>
                          </a:ext>
                        </a:extLst>
                      </p:cNvPr>
                      <p:cNvSpPr txBox="1"/>
                      <p:nvPr/>
                    </p:nvSpPr>
                    <p:spPr>
                      <a:xfrm rot="16200000">
                        <a:off x="5189740" y="3386945"/>
                        <a:ext cx="309094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square" rtlCol="0">
                        <a:spAutoFit/>
                      </a:bodyPr>
                      <a:lstStyle/>
                      <a:p>
                        <a:r>
                          <a:rPr lang="en-US" sz="1000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-2</a:t>
                        </a:r>
                      </a:p>
                    </p:txBody>
                  </p:sp>
                </p:grpSp>
                <p:sp>
                  <p:nvSpPr>
                    <p:cNvPr id="183" name="TextBox 182">
                      <a:extLst>
                        <a:ext uri="{FF2B5EF4-FFF2-40B4-BE49-F238E27FC236}">
                          <a16:creationId xmlns:a16="http://schemas.microsoft.com/office/drawing/2014/main" id="{E0E846DD-BFBE-641F-CADE-BFEDC3C3C0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863972" y="5991173"/>
                      <a:ext cx="885220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Z-score</a:t>
                      </a:r>
                    </a:p>
                  </p:txBody>
                </p:sp>
              </p:grpSp>
              <p:pic>
                <p:nvPicPr>
                  <p:cNvPr id="120" name="Picture 119" descr="A chart with different colored squares&#10;&#10;AI-generated content may be incorrect.">
                    <a:extLst>
                      <a:ext uri="{FF2B5EF4-FFF2-40B4-BE49-F238E27FC236}">
                        <a16:creationId xmlns:a16="http://schemas.microsoft.com/office/drawing/2014/main" id="{1F2F2AD0-B9F4-1D25-AFA7-3421DD3779BF}"/>
                      </a:ext>
                    </a:extLst>
                  </p:cNvPr>
                  <p:cNvPicPr preferRelativeResize="0">
                    <a:picLocks/>
                  </p:cNvPicPr>
                  <p:nvPr/>
                </p:nvPicPr>
                <p:blipFill>
                  <a:blip r:embed="rId19"/>
                  <a:srcRect l="71675" t="788" r="25105" b="69098"/>
                  <a:stretch/>
                </p:blipFill>
                <p:spPr>
                  <a:xfrm rot="5400000">
                    <a:off x="5541277" y="7678835"/>
                    <a:ext cx="155448" cy="876102"/>
                  </a:xfrm>
                  <a:prstGeom prst="rect">
                    <a:avLst/>
                  </a:prstGeom>
                </p:spPr>
              </p:pic>
            </p:grpSp>
          </p:grpSp>
          <p:pic>
            <p:nvPicPr>
              <p:cNvPr id="126" name="Picture 125" descr="A close-up of a screen&#10;&#10;Description automatically generated">
                <a:extLst>
                  <a:ext uri="{FF2B5EF4-FFF2-40B4-BE49-F238E27FC236}">
                    <a16:creationId xmlns:a16="http://schemas.microsoft.com/office/drawing/2014/main" id="{63A30F76-FC06-A25D-6213-2A2AA241E01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0357" t="282" r="6813" b="81873"/>
              <a:stretch/>
            </p:blipFill>
            <p:spPr>
              <a:xfrm rot="5400000" flipH="1">
                <a:off x="5408196" y="7412874"/>
                <a:ext cx="180463" cy="884844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7991410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sz="1200" dirty="0" smtClean="0">
            <a:solidFill>
              <a:srgbClr val="FF0000"/>
            </a:solidFill>
            <a:highlight>
              <a:srgbClr val="FFFF00"/>
            </a:highlight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3210</TotalTime>
  <Words>152</Words>
  <Application>Microsoft Office PowerPoint</Application>
  <PresentationFormat>Letter Paper (8.5x11 in)</PresentationFormat>
  <Paragraphs>9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10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nsulin regulates metabolism via zone-specific transcriptional programs</dc:title>
  <dc:creator>Biddinger Lab</dc:creator>
  <cp:lastModifiedBy>Schell, Mareike</cp:lastModifiedBy>
  <cp:revision>960</cp:revision>
  <cp:lastPrinted>2025-04-30T14:37:08Z</cp:lastPrinted>
  <dcterms:created xsi:type="dcterms:W3CDTF">2022-04-06T00:07:38Z</dcterms:created>
  <dcterms:modified xsi:type="dcterms:W3CDTF">2025-07-20T19:47:15Z</dcterms:modified>
</cp:coreProperties>
</file>